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457"/>
    <p:restoredTop sz="92892"/>
  </p:normalViewPr>
  <p:slideViewPr>
    <p:cSldViewPr snapToObjects="1">
      <p:cViewPr>
        <p:scale>
          <a:sx n="150" d="100"/>
          <a:sy n="150" d="100"/>
        </p:scale>
        <p:origin x="232" y="-2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rwanledeunff:Desktop:Figures%20%20frontiers%20AVG%20Glu%20:Corr&#233;lation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rwanledeunff:Desktop:Figures%20%20frontiers%20AVG%20Glu%20:Corr&#233;lation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rwanledeunff:Desktop:Figures%20%20frontiers%20AVG%20Glu%20:Corr&#233;lation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rwanledeunff:Desktop:Figures%20%20frontiers%20AVG%20Glu%20:Corr&#233;latio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6534629599871"/>
          <c:y val="0.0596153719169554"/>
          <c:w val="0.508747656542932"/>
          <c:h val="0.637196904721203"/>
        </c:manualLayout>
      </c:layout>
      <c:scatterChart>
        <c:scatterStyle val="lineMarker"/>
        <c:varyColors val="0"/>
        <c:ser>
          <c:idx val="0"/>
          <c:order val="0"/>
          <c:tx>
            <c:v>KNO3</c:v>
          </c:tx>
          <c:spPr>
            <a:ln w="31750">
              <a:noFill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noFill/>
              </a:ln>
              <a:effectLst/>
            </c:spPr>
          </c:marker>
          <c:trendline>
            <c:trendlineType val="log"/>
            <c:dispRSqr val="1"/>
            <c:dispEq val="1"/>
            <c:trendlineLbl>
              <c:layout>
                <c:manualLayout>
                  <c:x val="-0.117842144731909"/>
                  <c:y val="0.064532909164411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800">
                      <a:latin typeface="Times New Roman" charset="0"/>
                      <a:ea typeface="Times New Roman" charset="0"/>
                      <a:cs typeface="Times New Roman" charset="0"/>
                    </a:defRPr>
                  </a:pPr>
                  <a:endParaRPr lang="fr-FR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élations.xlsx]Feuil1'!$P$17:$P$23</c:f>
                <c:numCache>
                  <c:formatCode>General</c:formatCode>
                  <c:ptCount val="7"/>
                  <c:pt idx="0">
                    <c:v>0.194274479276213</c:v>
                  </c:pt>
                  <c:pt idx="1">
                    <c:v>0.187482338501493</c:v>
                  </c:pt>
                  <c:pt idx="2">
                    <c:v>0.19587577953753</c:v>
                  </c:pt>
                  <c:pt idx="3">
                    <c:v>0.0665864412312754</c:v>
                  </c:pt>
                  <c:pt idx="4">
                    <c:v>0.0180454030593692</c:v>
                  </c:pt>
                  <c:pt idx="5">
                    <c:v>0.077888389607343</c:v>
                  </c:pt>
                  <c:pt idx="6">
                    <c:v>0.0780193668776404</c:v>
                  </c:pt>
                </c:numCache>
              </c:numRef>
            </c:plus>
            <c:minus>
              <c:numRef>
                <c:f>'[Corrélations.xlsx]Feuil1'!$P$17:$P$23</c:f>
                <c:numCache>
                  <c:formatCode>General</c:formatCode>
                  <c:ptCount val="7"/>
                  <c:pt idx="0">
                    <c:v>0.194274479276213</c:v>
                  </c:pt>
                  <c:pt idx="1">
                    <c:v>0.187482338501493</c:v>
                  </c:pt>
                  <c:pt idx="2">
                    <c:v>0.19587577953753</c:v>
                  </c:pt>
                  <c:pt idx="3">
                    <c:v>0.0665864412312754</c:v>
                  </c:pt>
                  <c:pt idx="4">
                    <c:v>0.0180454030593692</c:v>
                  </c:pt>
                  <c:pt idx="5">
                    <c:v>0.077888389607343</c:v>
                  </c:pt>
                  <c:pt idx="6">
                    <c:v>0.0780193668776404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plus>
            <c:min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minus>
          </c:errBars>
          <c:xVal>
            <c:numRef>
              <c:f>'[Corrélations.xlsx]Feuil1'!$M$17:$M$23</c:f>
              <c:numCache>
                <c:formatCode>General</c:formatCode>
                <c:ptCount val="7"/>
                <c:pt idx="0">
                  <c:v>0.016884707492638</c:v>
                </c:pt>
                <c:pt idx="1">
                  <c:v>0.0853865351337705</c:v>
                </c:pt>
                <c:pt idx="2">
                  <c:v>0.227205291189361</c:v>
                </c:pt>
                <c:pt idx="3">
                  <c:v>1.0</c:v>
                </c:pt>
                <c:pt idx="4">
                  <c:v>1.623901594595437</c:v>
                </c:pt>
                <c:pt idx="5">
                  <c:v>2.366022676767832</c:v>
                </c:pt>
                <c:pt idx="6">
                  <c:v>3.144974462590242</c:v>
                </c:pt>
              </c:numCache>
            </c:numRef>
          </c:xVal>
          <c:yVal>
            <c:numRef>
              <c:f>'[Corrélations.xlsx]Feuil1'!$O$17:$O$23</c:f>
              <c:numCache>
                <c:formatCode>General</c:formatCode>
                <c:ptCount val="7"/>
                <c:pt idx="0">
                  <c:v>2.608852684917168</c:v>
                </c:pt>
                <c:pt idx="1">
                  <c:v>1.784554840183673</c:v>
                </c:pt>
                <c:pt idx="2">
                  <c:v>1.360968734818095</c:v>
                </c:pt>
                <c:pt idx="3">
                  <c:v>1.0</c:v>
                </c:pt>
                <c:pt idx="4">
                  <c:v>0.770766027045654</c:v>
                </c:pt>
                <c:pt idx="5">
                  <c:v>0.810660189482447</c:v>
                </c:pt>
                <c:pt idx="6">
                  <c:v>0.74011036414397</c:v>
                </c:pt>
              </c:numCache>
            </c:numRef>
          </c:yVal>
          <c:smooth val="0"/>
        </c:ser>
        <c:ser>
          <c:idx val="1"/>
          <c:order val="1"/>
          <c:tx>
            <c:v>Treatments</c:v>
          </c:tx>
          <c:spPr>
            <a:ln w="31750">
              <a:noFill/>
            </a:ln>
            <a:effectLst/>
          </c:spPr>
          <c:marker>
            <c:symbol val="circl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rrélations.xlsx]Feuil1'!$V$12:$V$14</c:f>
                <c:numCache>
                  <c:formatCode>General</c:formatCode>
                  <c:ptCount val="3"/>
                  <c:pt idx="0">
                    <c:v>0.142179999464936</c:v>
                  </c:pt>
                  <c:pt idx="1">
                    <c:v>0.0371450902637547</c:v>
                  </c:pt>
                  <c:pt idx="2">
                    <c:v>0.0086070779902443</c:v>
                  </c:pt>
                </c:numCache>
              </c:numRef>
            </c:plus>
            <c:minus>
              <c:numRef>
                <c:f>'[Corrélations.xlsx]Feuil1'!$V$12:$V$14</c:f>
                <c:numCache>
                  <c:formatCode>General</c:formatCode>
                  <c:ptCount val="3"/>
                  <c:pt idx="0">
                    <c:v>0.142179999464936</c:v>
                  </c:pt>
                  <c:pt idx="1">
                    <c:v>0.0371450902637547</c:v>
                  </c:pt>
                  <c:pt idx="2">
                    <c:v>0.0086070779902443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Z$12:$Z$14</c:f>
                <c:numCache>
                  <c:formatCode>General</c:formatCode>
                  <c:ptCount val="3"/>
                  <c:pt idx="0">
                    <c:v>0.0133269664840484</c:v>
                  </c:pt>
                  <c:pt idx="1">
                    <c:v>0.0249107667881825</c:v>
                  </c:pt>
                  <c:pt idx="2">
                    <c:v>0.129199216936404</c:v>
                  </c:pt>
                </c:numCache>
              </c:numRef>
            </c:plus>
            <c:minus>
              <c:numRef>
                <c:f>'[Corrélations.xlsx]Feuil1'!$Z$12:$Z$14</c:f>
                <c:numCache>
                  <c:formatCode>General</c:formatCode>
                  <c:ptCount val="3"/>
                  <c:pt idx="0">
                    <c:v>0.0133269664840484</c:v>
                  </c:pt>
                  <c:pt idx="1">
                    <c:v>0.0249107667881825</c:v>
                  </c:pt>
                  <c:pt idx="2">
                    <c:v>0.129199216936404</c:v>
                  </c:pt>
                </c:numCache>
              </c:numRef>
            </c:minus>
          </c:errBars>
          <c:xVal>
            <c:numRef>
              <c:f>'[Corrélations.xlsx]Feuil1'!$Y$12:$Y$14</c:f>
              <c:numCache>
                <c:formatCode>General</c:formatCode>
                <c:ptCount val="3"/>
                <c:pt idx="0">
                  <c:v>1.0</c:v>
                </c:pt>
                <c:pt idx="1">
                  <c:v>1.25242718446602</c:v>
                </c:pt>
                <c:pt idx="2">
                  <c:v>1.698417210377081</c:v>
                </c:pt>
              </c:numCache>
            </c:numRef>
          </c:xVal>
          <c:yVal>
            <c:numRef>
              <c:f>'[Corrélations.xlsx]Feuil1'!$U$12:$U$14</c:f>
              <c:numCache>
                <c:formatCode>General</c:formatCode>
                <c:ptCount val="3"/>
                <c:pt idx="0">
                  <c:v>1.0</c:v>
                </c:pt>
                <c:pt idx="1">
                  <c:v>0.901035558380211</c:v>
                </c:pt>
                <c:pt idx="2">
                  <c:v>0.7600436751262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13747616"/>
        <c:axId val="-414967408"/>
      </c:scatterChart>
      <c:valAx>
        <c:axId val="-813747616"/>
        <c:scaling>
          <c:logBase val="10.0"/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noProof="1">
                    <a:latin typeface="Times New Roman" charset="0"/>
                    <a:ea typeface="Times New Roman" charset="0"/>
                    <a:cs typeface="Times New Roman" charset="0"/>
                  </a:rPr>
                  <a:t>Normalized</a:t>
                </a:r>
                <a:r>
                  <a:rPr lang="en-GB" baseline="0" noProof="1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en-GB" sz="1000" baseline="30000" noProof="1">
                    <a:latin typeface="Times New Roman" charset="0"/>
                    <a:ea typeface="Times New Roman" charset="0"/>
                    <a:cs typeface="Times New Roman" charset="0"/>
                  </a:rPr>
                  <a:t>15</a:t>
                </a:r>
                <a:r>
                  <a:rPr lang="en-GB" baseline="0" noProof="1">
                    <a:latin typeface="Times New Roman" charset="0"/>
                    <a:ea typeface="Times New Roman" charset="0"/>
                    <a:cs typeface="Times New Roman" charset="0"/>
                  </a:rPr>
                  <a:t>N accumulation in </a:t>
                </a:r>
                <a:r>
                  <a:rPr lang="en-GB" baseline="0" noProof="1" smtClean="0">
                    <a:latin typeface="Times New Roman" charset="0"/>
                    <a:ea typeface="Times New Roman" charset="0"/>
                    <a:cs typeface="Times New Roman" charset="0"/>
                  </a:rPr>
                  <a:t>shoots</a:t>
                </a:r>
              </a:p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baseline="0" noProof="1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en-GB" b="0" baseline="0" noProof="1">
                    <a:latin typeface="Times New Roman" charset="0"/>
                    <a:ea typeface="Times New Roman" charset="0"/>
                    <a:cs typeface="Times New Roman" charset="0"/>
                  </a:rPr>
                  <a:t>(dimensionless)</a:t>
                </a:r>
                <a:endParaRPr lang="en-GB" b="0" noProof="1">
                  <a:latin typeface="Times New Roman" charset="0"/>
                  <a:ea typeface="Times New Roman" charset="0"/>
                  <a:cs typeface="Times New Roman" charset="0"/>
                </a:endParaRPr>
              </a:p>
            </c:rich>
          </c:tx>
          <c:layout>
            <c:manualLayout>
              <c:xMode val="edge"/>
              <c:yMode val="edge"/>
              <c:x val="0.26445497884193"/>
              <c:y val="0.81215191136473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414967408"/>
        <c:crosses val="autoZero"/>
        <c:crossBetween val="midCat"/>
      </c:valAx>
      <c:valAx>
        <c:axId val="-414967408"/>
        <c:scaling>
          <c:orientation val="minMax"/>
        </c:scaling>
        <c:delete val="1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000" b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fr-FR" sz="1000" b="1" i="0" baseline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Normalized Trp content in shoots </a:t>
                </a:r>
                <a:endParaRPr lang="fr-FR" sz="1000" b="1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  <a:p>
                <a:pPr>
                  <a:defRPr sz="1000" b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fr-FR" sz="1000" b="0" i="0" baseline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(dimensionless)</a:t>
                </a:r>
                <a:endParaRPr lang="fr-FR" sz="1000" b="0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</c:rich>
          </c:tx>
          <c:layout>
            <c:manualLayout>
              <c:xMode val="edge"/>
              <c:yMode val="edge"/>
              <c:x val="0.14667068402164"/>
              <c:y val="0.059615371916955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813747616"/>
        <c:crossesAt val="0.01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egendEntry>
        <c:idx val="2"/>
        <c:delete val="1"/>
      </c:legendEntry>
      <c:layout>
        <c:manualLayout>
          <c:xMode val="edge"/>
          <c:yMode val="edge"/>
          <c:x val="0.565947827950078"/>
          <c:y val="0.175460516999895"/>
          <c:w val="0.206291445712143"/>
          <c:h val="0.119061995819451"/>
        </c:manualLayout>
      </c:layout>
      <c:overlay val="0"/>
      <c:txPr>
        <a:bodyPr/>
        <a:lstStyle/>
        <a:p>
          <a:pPr>
            <a:defRPr sz="800" b="1">
              <a:latin typeface="Times New Roman" charset="0"/>
              <a:ea typeface="Times New Roman" charset="0"/>
              <a:cs typeface="Times New Roman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6178128072495"/>
          <c:y val="0.0647782241144192"/>
          <c:w val="0.536504300542884"/>
          <c:h val="0.631793649054307"/>
        </c:manualLayout>
      </c:layout>
      <c:scatterChart>
        <c:scatterStyle val="lineMarker"/>
        <c:varyColors val="0"/>
        <c:ser>
          <c:idx val="0"/>
          <c:order val="0"/>
          <c:tx>
            <c:v>Shoot surface area</c:v>
          </c:tx>
          <c:spPr>
            <a:ln w="31750">
              <a:noFill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noFill/>
              </a:ln>
              <a:effectLst/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0.0766638584667228"/>
                  <c:y val="0.394939150849528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800">
                      <a:latin typeface="Times New Roman" charset="0"/>
                      <a:ea typeface="Times New Roman" charset="0"/>
                      <a:cs typeface="Times New Roman" charset="0"/>
                    </a:defRPr>
                  </a:pPr>
                  <a:endParaRPr lang="fr-FR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plus>
            <c:min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C$17:$C$23</c:f>
                <c:numCache>
                  <c:formatCode>General</c:formatCode>
                  <c:ptCount val="7"/>
                  <c:pt idx="0">
                    <c:v>0.0106494981053733</c:v>
                  </c:pt>
                  <c:pt idx="1">
                    <c:v>0.06288623481633</c:v>
                  </c:pt>
                  <c:pt idx="2">
                    <c:v>0.0974585226241628</c:v>
                  </c:pt>
                  <c:pt idx="3">
                    <c:v>0.0430973459519827</c:v>
                  </c:pt>
                  <c:pt idx="4">
                    <c:v>0.106184488213528</c:v>
                  </c:pt>
                  <c:pt idx="5">
                    <c:v>0.17581462461352</c:v>
                  </c:pt>
                  <c:pt idx="6">
                    <c:v>0.0866011137224838</c:v>
                  </c:pt>
                </c:numCache>
              </c:numRef>
            </c:plus>
            <c:minus>
              <c:numRef>
                <c:f>'[Corrélations.xlsx]Feuil1'!$C$17:$C$23</c:f>
                <c:numCache>
                  <c:formatCode>General</c:formatCode>
                  <c:ptCount val="7"/>
                  <c:pt idx="0">
                    <c:v>0.0106494981053733</c:v>
                  </c:pt>
                  <c:pt idx="1">
                    <c:v>0.06288623481633</c:v>
                  </c:pt>
                  <c:pt idx="2">
                    <c:v>0.0974585226241628</c:v>
                  </c:pt>
                  <c:pt idx="3">
                    <c:v>0.0430973459519827</c:v>
                  </c:pt>
                  <c:pt idx="4">
                    <c:v>0.106184488213528</c:v>
                  </c:pt>
                  <c:pt idx="5">
                    <c:v>0.17581462461352</c:v>
                  </c:pt>
                  <c:pt idx="6">
                    <c:v>0.0866011137224838</c:v>
                  </c:pt>
                </c:numCache>
              </c:numRef>
            </c:minus>
          </c:errBars>
          <c:xVal>
            <c:numRef>
              <c:f>'[Corrélations.xlsx]Feuil1'!$B$17:$B$23</c:f>
              <c:numCache>
                <c:formatCode>General</c:formatCode>
                <c:ptCount val="7"/>
                <c:pt idx="0">
                  <c:v>0.682701022918555</c:v>
                </c:pt>
                <c:pt idx="1">
                  <c:v>0.72895895377444</c:v>
                </c:pt>
                <c:pt idx="2">
                  <c:v>0.859801890457076</c:v>
                </c:pt>
                <c:pt idx="3">
                  <c:v>1.0</c:v>
                </c:pt>
                <c:pt idx="4">
                  <c:v>1.233070050498511</c:v>
                </c:pt>
                <c:pt idx="5">
                  <c:v>1.431082480901204</c:v>
                </c:pt>
                <c:pt idx="6">
                  <c:v>1.778486339505374</c:v>
                </c:pt>
              </c:numCache>
            </c:numRef>
          </c:xVal>
          <c:yVal>
            <c:numRef>
              <c:f>'[Corrélations.xlsx]Feuil1'!$M$17:$M$23</c:f>
              <c:numCache>
                <c:formatCode>General</c:formatCode>
                <c:ptCount val="7"/>
                <c:pt idx="0">
                  <c:v>0.016884707492638</c:v>
                </c:pt>
                <c:pt idx="1">
                  <c:v>0.0853865351337705</c:v>
                </c:pt>
                <c:pt idx="2">
                  <c:v>0.227205291189361</c:v>
                </c:pt>
                <c:pt idx="3">
                  <c:v>1.0</c:v>
                </c:pt>
                <c:pt idx="4">
                  <c:v>1.623901594595437</c:v>
                </c:pt>
                <c:pt idx="5">
                  <c:v>2.366022676767832</c:v>
                </c:pt>
                <c:pt idx="6">
                  <c:v>3.144974462590242</c:v>
                </c:pt>
              </c:numCache>
            </c:numRef>
          </c:yVal>
          <c:smooth val="0"/>
        </c:ser>
        <c:ser>
          <c:idx val="1"/>
          <c:order val="1"/>
          <c:tx>
            <c:v>shoot FW</c:v>
          </c:tx>
          <c:spPr>
            <a:ln w="31750">
              <a:noFill/>
            </a:ln>
            <a:effectLst/>
          </c:spPr>
          <c:marker>
            <c:symbol val="circle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78927748008481"/>
                  <c:y val="0.273182212485153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800">
                      <a:latin typeface="Times New Roman" charset="0"/>
                      <a:ea typeface="Times New Roman" charset="0"/>
                      <a:cs typeface="Times New Roman" charset="0"/>
                    </a:defRPr>
                  </a:pPr>
                  <a:endParaRPr lang="fr-FR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plus>
            <c:minus>
              <c:numRef>
                <c:f>'[Corrélations.xlsx]Feuil1'!$N$17:$N$23</c:f>
                <c:numCache>
                  <c:formatCode>General</c:formatCode>
                  <c:ptCount val="7"/>
                  <c:pt idx="0">
                    <c:v>0.000410426593326031</c:v>
                  </c:pt>
                  <c:pt idx="1">
                    <c:v>0.00320667522248693</c:v>
                  </c:pt>
                  <c:pt idx="2">
                    <c:v>0.00896127133865319</c:v>
                  </c:pt>
                  <c:pt idx="3">
                    <c:v>0.0990547444410231</c:v>
                  </c:pt>
                  <c:pt idx="4">
                    <c:v>0.122771494027536</c:v>
                  </c:pt>
                  <c:pt idx="5">
                    <c:v>0.373957472719231</c:v>
                  </c:pt>
                  <c:pt idx="6">
                    <c:v>0.209233283213375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H$17:$H$23</c:f>
                <c:numCache>
                  <c:formatCode>General</c:formatCode>
                  <c:ptCount val="7"/>
                  <c:pt idx="0">
                    <c:v>0.0136882629629695</c:v>
                  </c:pt>
                  <c:pt idx="1">
                    <c:v>0.0562860467798687</c:v>
                  </c:pt>
                  <c:pt idx="2">
                    <c:v>0.0980527444353003</c:v>
                  </c:pt>
                  <c:pt idx="3">
                    <c:v>0.0413825843848678</c:v>
                  </c:pt>
                  <c:pt idx="4">
                    <c:v>0.124534287823475</c:v>
                  </c:pt>
                  <c:pt idx="5">
                    <c:v>0.172415838510249</c:v>
                  </c:pt>
                  <c:pt idx="6">
                    <c:v>0.196575841874507</c:v>
                  </c:pt>
                </c:numCache>
              </c:numRef>
            </c:plus>
            <c:minus>
              <c:numRef>
                <c:f>'[Corrélations.xlsx]Feuil1'!$H$17:$H$23</c:f>
                <c:numCache>
                  <c:formatCode>General</c:formatCode>
                  <c:ptCount val="7"/>
                  <c:pt idx="0">
                    <c:v>0.0136882629629695</c:v>
                  </c:pt>
                  <c:pt idx="1">
                    <c:v>0.0562860467798687</c:v>
                  </c:pt>
                  <c:pt idx="2">
                    <c:v>0.0980527444353003</c:v>
                  </c:pt>
                  <c:pt idx="3">
                    <c:v>0.0413825843848678</c:v>
                  </c:pt>
                  <c:pt idx="4">
                    <c:v>0.124534287823475</c:v>
                  </c:pt>
                  <c:pt idx="5">
                    <c:v>0.172415838510249</c:v>
                  </c:pt>
                  <c:pt idx="6">
                    <c:v>0.196575841874507</c:v>
                  </c:pt>
                </c:numCache>
              </c:numRef>
            </c:minus>
          </c:errBars>
          <c:xVal>
            <c:numRef>
              <c:f>'[Corrélations.xlsx]Feuil1'!$G$17:$G$23</c:f>
              <c:numCache>
                <c:formatCode>General</c:formatCode>
                <c:ptCount val="7"/>
                <c:pt idx="0">
                  <c:v>0.640409160858151</c:v>
                </c:pt>
                <c:pt idx="1">
                  <c:v>0.681723544853806</c:v>
                </c:pt>
                <c:pt idx="2">
                  <c:v>0.762080202769983</c:v>
                </c:pt>
                <c:pt idx="3">
                  <c:v>1.0</c:v>
                </c:pt>
                <c:pt idx="4">
                  <c:v>1.203376482302887</c:v>
                </c:pt>
                <c:pt idx="5">
                  <c:v>1.449171720829184</c:v>
                </c:pt>
                <c:pt idx="6">
                  <c:v>1.70679822576265</c:v>
                </c:pt>
              </c:numCache>
            </c:numRef>
          </c:xVal>
          <c:yVal>
            <c:numRef>
              <c:f>'[Corrélations.xlsx]Feuil1'!$M$17:$M$23</c:f>
              <c:numCache>
                <c:formatCode>General</c:formatCode>
                <c:ptCount val="7"/>
                <c:pt idx="0">
                  <c:v>0.016884707492638</c:v>
                </c:pt>
                <c:pt idx="1">
                  <c:v>0.0853865351337705</c:v>
                </c:pt>
                <c:pt idx="2">
                  <c:v>0.227205291189361</c:v>
                </c:pt>
                <c:pt idx="3">
                  <c:v>1.0</c:v>
                </c:pt>
                <c:pt idx="4">
                  <c:v>1.623901594595437</c:v>
                </c:pt>
                <c:pt idx="5">
                  <c:v>2.366022676767832</c:v>
                </c:pt>
                <c:pt idx="6">
                  <c:v>3.1449744625902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619145328"/>
        <c:axId val="-813993040"/>
      </c:scatterChart>
      <c:valAx>
        <c:axId val="-619145328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fr-FR">
                    <a:latin typeface="Times New Roman" charset="0"/>
                    <a:ea typeface="Times New Roman" charset="0"/>
                    <a:cs typeface="Times New Roman" charset="0"/>
                  </a:rPr>
                  <a:t>Normalized FW and surface area of shoots</a:t>
                </a:r>
                <a:r>
                  <a:rPr lang="fr-FR" baseline="0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fr-FR" b="0">
                    <a:latin typeface="Times New Roman" charset="0"/>
                    <a:ea typeface="Times New Roman" charset="0"/>
                    <a:cs typeface="Times New Roman" charset="0"/>
                  </a:rPr>
                  <a:t>(dimensionless) </a:t>
                </a:r>
              </a:p>
            </c:rich>
          </c:tx>
          <c:layout>
            <c:manualLayout>
              <c:xMode val="edge"/>
              <c:yMode val="edge"/>
              <c:x val="0.13261187083256"/>
              <c:y val="0.7885644570009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813993040"/>
        <c:crosses val="autoZero"/>
        <c:crossBetween val="midCat"/>
      </c:valAx>
      <c:valAx>
        <c:axId val="-813993040"/>
        <c:scaling>
          <c:orientation val="minMax"/>
          <c:min val="0.0"/>
        </c:scaling>
        <c:delete val="1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noProof="1">
                    <a:latin typeface="Times New Roman" charset="0"/>
                    <a:ea typeface="Times New Roman" charset="0"/>
                    <a:cs typeface="Times New Roman" charset="0"/>
                  </a:rPr>
                  <a:t>Normalized</a:t>
                </a:r>
                <a:r>
                  <a:rPr lang="en-GB" baseline="0" noProof="1" smtClean="0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en-GB" baseline="30000" noProof="1" smtClean="0">
                    <a:latin typeface="Times New Roman" charset="0"/>
                    <a:ea typeface="Times New Roman" charset="0"/>
                    <a:cs typeface="Times New Roman" charset="0"/>
                  </a:rPr>
                  <a:t>15</a:t>
                </a:r>
                <a:r>
                  <a:rPr lang="en-GB" baseline="0" noProof="1" smtClean="0">
                    <a:latin typeface="Times New Roman" charset="0"/>
                    <a:ea typeface="Times New Roman" charset="0"/>
                    <a:cs typeface="Times New Roman" charset="0"/>
                  </a:rPr>
                  <a:t>N </a:t>
                </a:r>
                <a:r>
                  <a:rPr lang="en-GB" noProof="1">
                    <a:latin typeface="Times New Roman" charset="0"/>
                    <a:ea typeface="Times New Roman" charset="0"/>
                    <a:cs typeface="Times New Roman" charset="0"/>
                  </a:rPr>
                  <a:t>amount in shoots </a:t>
                </a:r>
              </a:p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b="0" noProof="1">
                    <a:latin typeface="Times New Roman" charset="0"/>
                    <a:ea typeface="Times New Roman" charset="0"/>
                    <a:cs typeface="Times New Roman" charset="0"/>
                  </a:rPr>
                  <a:t>(dimensionless)</a:t>
                </a:r>
              </a:p>
            </c:rich>
          </c:tx>
          <c:layout>
            <c:manualLayout>
              <c:xMode val="edge"/>
              <c:yMode val="edge"/>
              <c:x val="0.0545898869335948"/>
              <c:y val="0.069432569348827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619145328"/>
        <c:crossesAt val="0.01"/>
        <c:crossBetween val="midCat"/>
      </c:valAx>
      <c:spPr>
        <a:ln w="0">
          <a:solidFill>
            <a:schemeClr val="tx1"/>
          </a:solidFill>
          <a:prstDash val="solid"/>
        </a:ln>
      </c:spPr>
    </c:plotArea>
    <c:legend>
      <c:legendPos val="r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288187742756125"/>
          <c:y val="0.144483868364131"/>
          <c:w val="0.300259155665382"/>
          <c:h val="0.140958494601509"/>
        </c:manualLayout>
      </c:layout>
      <c:overlay val="0"/>
      <c:txPr>
        <a:bodyPr/>
        <a:lstStyle/>
        <a:p>
          <a:pPr>
            <a:defRPr sz="800" b="1">
              <a:latin typeface="Times New Roman" charset="0"/>
              <a:ea typeface="Times New Roman" charset="0"/>
              <a:cs typeface="Times New Roman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110798509164"/>
          <c:y val="0.076541298771062"/>
          <c:w val="0.593520703031275"/>
          <c:h val="0.625794123826639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0159530706160618"/>
                  <c:y val="0.27068332013253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Times New Roman" charset="0"/>
                      <a:ea typeface="Times New Roman" charset="0"/>
                      <a:cs typeface="Times New Roman" charset="0"/>
                    </a:defRPr>
                  </a:pPr>
                  <a:endParaRPr lang="fr-FR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élations.xlsx]Feuil1'!$P$28:$P$34</c:f>
                <c:numCache>
                  <c:formatCode>General</c:formatCode>
                  <c:ptCount val="7"/>
                  <c:pt idx="0">
                    <c:v>0.00692685461864278</c:v>
                  </c:pt>
                  <c:pt idx="1">
                    <c:v>0.0107530063304416</c:v>
                  </c:pt>
                  <c:pt idx="2">
                    <c:v>0.00532153164965557</c:v>
                  </c:pt>
                  <c:pt idx="3">
                    <c:v>0.00212132751587134</c:v>
                  </c:pt>
                  <c:pt idx="4">
                    <c:v>0.0200201565967384</c:v>
                  </c:pt>
                  <c:pt idx="5">
                    <c:v>0.0135637817748832</c:v>
                  </c:pt>
                  <c:pt idx="6">
                    <c:v>0.0189879045588745</c:v>
                  </c:pt>
                </c:numCache>
              </c:numRef>
            </c:plus>
            <c:minus>
              <c:numRef>
                <c:f>'[Corrélations.xlsx]Feuil1'!$P$28:$P$34</c:f>
                <c:numCache>
                  <c:formatCode>General</c:formatCode>
                  <c:ptCount val="7"/>
                  <c:pt idx="0">
                    <c:v>0.00692685461864278</c:v>
                  </c:pt>
                  <c:pt idx="1">
                    <c:v>0.0107530063304416</c:v>
                  </c:pt>
                  <c:pt idx="2">
                    <c:v>0.00532153164965557</c:v>
                  </c:pt>
                  <c:pt idx="3">
                    <c:v>0.00212132751587134</c:v>
                  </c:pt>
                  <c:pt idx="4">
                    <c:v>0.0200201565967384</c:v>
                  </c:pt>
                  <c:pt idx="5">
                    <c:v>0.0135637817748832</c:v>
                  </c:pt>
                  <c:pt idx="6">
                    <c:v>0.0189879045588745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G$28:$G$34</c:f>
                <c:numCache>
                  <c:formatCode>General</c:formatCode>
                  <c:ptCount val="7"/>
                  <c:pt idx="0">
                    <c:v>0.203899485041035</c:v>
                  </c:pt>
                  <c:pt idx="1">
                    <c:v>0.597452927016026</c:v>
                  </c:pt>
                  <c:pt idx="2">
                    <c:v>0.634126696068394</c:v>
                  </c:pt>
                  <c:pt idx="3">
                    <c:v>0.0934968805183778</c:v>
                  </c:pt>
                  <c:pt idx="4">
                    <c:v>0.499055357650817</c:v>
                  </c:pt>
                  <c:pt idx="5">
                    <c:v>0.482087474773328</c:v>
                  </c:pt>
                  <c:pt idx="6">
                    <c:v>0.520390478391017</c:v>
                  </c:pt>
                </c:numCache>
              </c:numRef>
            </c:plus>
            <c:minus>
              <c:numRef>
                <c:f>'[Corrélations.xlsx]Feuil1'!$G$28:$G$34</c:f>
                <c:numCache>
                  <c:formatCode>General</c:formatCode>
                  <c:ptCount val="7"/>
                  <c:pt idx="0">
                    <c:v>0.203899485041035</c:v>
                  </c:pt>
                  <c:pt idx="1">
                    <c:v>0.597452927016026</c:v>
                  </c:pt>
                  <c:pt idx="2">
                    <c:v>0.634126696068394</c:v>
                  </c:pt>
                  <c:pt idx="3">
                    <c:v>0.0934968805183778</c:v>
                  </c:pt>
                  <c:pt idx="4">
                    <c:v>0.499055357650817</c:v>
                  </c:pt>
                  <c:pt idx="5">
                    <c:v>0.482087474773328</c:v>
                  </c:pt>
                  <c:pt idx="6">
                    <c:v>0.520390478391017</c:v>
                  </c:pt>
                </c:numCache>
              </c:numRef>
            </c:minus>
          </c:errBars>
          <c:xVal>
            <c:numRef>
              <c:f>'[Corrélations.xlsx]Feuil1'!$F$28:$F$34</c:f>
              <c:numCache>
                <c:formatCode>General</c:formatCode>
                <c:ptCount val="7"/>
                <c:pt idx="0" formatCode="0.00">
                  <c:v>5.084999999999923</c:v>
                </c:pt>
                <c:pt idx="1">
                  <c:v>5.88</c:v>
                </c:pt>
                <c:pt idx="2" formatCode="0.00">
                  <c:v>5.99000000000001</c:v>
                </c:pt>
                <c:pt idx="3" formatCode="0.00">
                  <c:v>5.774999999999977</c:v>
                </c:pt>
                <c:pt idx="4" formatCode="0.00">
                  <c:v>4.487500000000068</c:v>
                </c:pt>
                <c:pt idx="5" formatCode="0.00">
                  <c:v>4.704999999999984</c:v>
                </c:pt>
                <c:pt idx="6" formatCode="0.00">
                  <c:v>5.072500000000048</c:v>
                </c:pt>
              </c:numCache>
            </c:numRef>
          </c:xVal>
          <c:yVal>
            <c:numRef>
              <c:f>'[Corrélations.xlsx]Feuil1'!$O$28:$O$34</c:f>
              <c:numCache>
                <c:formatCode>General</c:formatCode>
                <c:ptCount val="7"/>
                <c:pt idx="0">
                  <c:v>0.174670057159594</c:v>
                </c:pt>
                <c:pt idx="1">
                  <c:v>0.152329789536085</c:v>
                </c:pt>
                <c:pt idx="2">
                  <c:v>0.132626160135372</c:v>
                </c:pt>
                <c:pt idx="3">
                  <c:v>0.15279362445825</c:v>
                </c:pt>
                <c:pt idx="4">
                  <c:v>0.206893732621799</c:v>
                </c:pt>
                <c:pt idx="5">
                  <c:v>0.178797884828987</c:v>
                </c:pt>
                <c:pt idx="6">
                  <c:v>0.1571074921049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14109776"/>
        <c:axId val="-814064384"/>
      </c:scatterChart>
      <c:valAx>
        <c:axId val="-814109776"/>
        <c:scaling>
          <c:orientation val="minMax"/>
          <c:min val="3.5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en-GB" sz="1000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sz="1000" b="1" i="0" baseline="0" noProof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Root DW </a:t>
                </a:r>
                <a:r>
                  <a:rPr lang="en-GB" sz="1000" b="0" i="0" baseline="0" noProof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(in mg)</a:t>
                </a:r>
                <a:endParaRPr lang="en-GB" sz="1000" noProof="1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</c:rich>
          </c:tx>
          <c:layout>
            <c:manualLayout>
              <c:xMode val="edge"/>
              <c:yMode val="edge"/>
              <c:x val="0.353398030368395"/>
              <c:y val="0.78930872328642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-814064384"/>
        <c:crosses val="autoZero"/>
        <c:crossBetween val="midCat"/>
      </c:valAx>
      <c:valAx>
        <c:axId val="-814064384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1000" spc="-10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fr-FR" sz="1000" b="1" i="0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fr-FR" sz="1000" b="1" i="0" spc="-100" baseline="0" dirty="0" err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Trp</a:t>
                </a:r>
                <a:r>
                  <a:rPr lang="fr-FR" sz="1000" b="1" i="0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 contents  in </a:t>
                </a:r>
                <a:r>
                  <a:rPr lang="fr-FR" sz="1000" b="1" i="0" spc="-100" baseline="0" dirty="0" err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roots</a:t>
                </a:r>
                <a:endParaRPr lang="fr-FR" sz="1000" spc="-100" dirty="0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  <a:p>
                <a:pPr>
                  <a:defRPr sz="1000" spc="-10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fr-FR" sz="1000" b="0" i="0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(</a:t>
                </a:r>
                <a:r>
                  <a:rPr lang="fr-FR" sz="1000" b="0" i="0" u="none" strike="noStrike" spc="-100" baseline="0" dirty="0" err="1">
                    <a:effectLst/>
                    <a:latin typeface="Symbol" charset="2"/>
                    <a:ea typeface="Symbol" charset="2"/>
                    <a:cs typeface="Symbol" charset="2"/>
                  </a:rPr>
                  <a:t>m</a:t>
                </a:r>
                <a:r>
                  <a:rPr lang="fr-FR" sz="1000" b="0" i="0" u="none" strike="noStrike" spc="-100" baseline="0" dirty="0" err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moles</a:t>
                </a:r>
                <a:r>
                  <a:rPr lang="fr-FR" sz="1000" b="0" i="0" u="none" strike="noStrike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 mg </a:t>
                </a:r>
                <a:r>
                  <a:rPr lang="fr-FR" sz="1000" b="0" i="0" u="none" strike="noStrike" spc="-100" baseline="3000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-1 </a:t>
                </a:r>
                <a:r>
                  <a:rPr lang="fr-FR" sz="1000" b="0" i="0" u="none" strike="noStrike" spc="-100" baseline="0" dirty="0" err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root</a:t>
                </a:r>
                <a:r>
                  <a:rPr lang="fr-FR" sz="1000" b="0" i="0" u="none" strike="noStrike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fr-FR" sz="1000" b="0" i="0" u="none" strike="noStrike" spc="-100" baseline="0" dirty="0" smtClean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 DW</a:t>
                </a:r>
                <a:r>
                  <a:rPr lang="fr-FR" sz="1000" b="1" i="0" u="none" strike="noStrike" spc="-100" baseline="0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 </a:t>
                </a:r>
                <a:r>
                  <a:rPr lang="fr-FR" sz="1000" b="0" i="0" spc="-100" baseline="0" dirty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)</a:t>
                </a:r>
                <a:endParaRPr lang="fr-FR" sz="1000" b="0" spc="-100" dirty="0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</c:rich>
          </c:tx>
          <c:layout>
            <c:manualLayout>
              <c:xMode val="edge"/>
              <c:yMode val="edge"/>
              <c:x val="0.0265964289582158"/>
              <c:y val="0.176072929068741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-81410977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3820558464251"/>
          <c:y val="0.124811613571344"/>
          <c:w val="0.533858643013507"/>
          <c:h val="0.626538187845496"/>
        </c:manualLayout>
      </c:layout>
      <c:scatterChart>
        <c:scatterStyle val="lineMarker"/>
        <c:varyColors val="0"/>
        <c:ser>
          <c:idx val="0"/>
          <c:order val="0"/>
          <c:tx>
            <c:v>KNO3</c:v>
          </c:tx>
          <c:spPr>
            <a:ln w="19050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0701954251844314"/>
                  <c:y val="0.29068893748607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Times New Roman" charset="0"/>
                      <a:ea typeface="Times New Roman" charset="0"/>
                      <a:cs typeface="Times New Roman" charset="0"/>
                    </a:defRPr>
                  </a:pPr>
                  <a:endParaRPr lang="fr-FR"/>
                </a:p>
              </c:txPr>
            </c:trendlineLbl>
          </c:trendline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[Corrélations.xlsx]Feuil1'!$P$36:$P$42</c:f>
                <c:numCache>
                  <c:formatCode>General</c:formatCode>
                  <c:ptCount val="7"/>
                  <c:pt idx="0">
                    <c:v>0.0453347097642512</c:v>
                  </c:pt>
                  <c:pt idx="1">
                    <c:v>0.0703760145003944</c:v>
                  </c:pt>
                  <c:pt idx="2">
                    <c:v>0.0348282310111024</c:v>
                  </c:pt>
                  <c:pt idx="3">
                    <c:v>0.0138836127711008</c:v>
                  </c:pt>
                  <c:pt idx="4">
                    <c:v>0.131027434343039</c:v>
                  </c:pt>
                  <c:pt idx="5">
                    <c:v>0.0887719093186991</c:v>
                  </c:pt>
                  <c:pt idx="6">
                    <c:v>0.124271576292522</c:v>
                  </c:pt>
                </c:numCache>
              </c:numRef>
            </c:plus>
            <c:minus>
              <c:numRef>
                <c:f>'[Corrélations.xlsx]Feuil1'!$P$36:$P$42</c:f>
                <c:numCache>
                  <c:formatCode>General</c:formatCode>
                  <c:ptCount val="7"/>
                  <c:pt idx="0">
                    <c:v>0.0453347097642512</c:v>
                  </c:pt>
                  <c:pt idx="1">
                    <c:v>0.0703760145003944</c:v>
                  </c:pt>
                  <c:pt idx="2">
                    <c:v>0.0348282310111024</c:v>
                  </c:pt>
                  <c:pt idx="3">
                    <c:v>0.0138836127711008</c:v>
                  </c:pt>
                  <c:pt idx="4">
                    <c:v>0.131027434343039</c:v>
                  </c:pt>
                  <c:pt idx="5">
                    <c:v>0.0887719093186991</c:v>
                  </c:pt>
                  <c:pt idx="6">
                    <c:v>0.124271576292522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G$36:$G$42</c:f>
                <c:numCache>
                  <c:formatCode>General</c:formatCode>
                  <c:ptCount val="7"/>
                  <c:pt idx="0">
                    <c:v>0.035307270136976</c:v>
                  </c:pt>
                  <c:pt idx="1">
                    <c:v>0.103455052297148</c:v>
                  </c:pt>
                  <c:pt idx="2">
                    <c:v>0.109805488496692</c:v>
                  </c:pt>
                  <c:pt idx="3">
                    <c:v>0.0161899360204984</c:v>
                  </c:pt>
                  <c:pt idx="4">
                    <c:v>0.0864165121473279</c:v>
                  </c:pt>
                  <c:pt idx="5">
                    <c:v>0.0834783506101004</c:v>
                  </c:pt>
                  <c:pt idx="6">
                    <c:v>0.0901109053490941</c:v>
                  </c:pt>
                </c:numCache>
              </c:numRef>
            </c:plus>
            <c:minus>
              <c:numRef>
                <c:f>'[Corrélations.xlsx]Feuil1'!$G$36:$G$42</c:f>
                <c:numCache>
                  <c:formatCode>General</c:formatCode>
                  <c:ptCount val="7"/>
                  <c:pt idx="0">
                    <c:v>0.035307270136976</c:v>
                  </c:pt>
                  <c:pt idx="1">
                    <c:v>0.103455052297148</c:v>
                  </c:pt>
                  <c:pt idx="2">
                    <c:v>0.109805488496692</c:v>
                  </c:pt>
                  <c:pt idx="3">
                    <c:v>0.0161899360204984</c:v>
                  </c:pt>
                  <c:pt idx="4">
                    <c:v>0.0864165121473279</c:v>
                  </c:pt>
                  <c:pt idx="5">
                    <c:v>0.0834783506101004</c:v>
                  </c:pt>
                  <c:pt idx="6">
                    <c:v>0.0901109053490941</c:v>
                  </c:pt>
                </c:numCache>
              </c:numRef>
            </c:minus>
          </c:errBars>
          <c:xVal>
            <c:numRef>
              <c:f>'[Corrélations.xlsx]Feuil1'!$F$36:$F$42</c:f>
              <c:numCache>
                <c:formatCode>General</c:formatCode>
                <c:ptCount val="7"/>
                <c:pt idx="0">
                  <c:v>0.880519480519471</c:v>
                </c:pt>
                <c:pt idx="1">
                  <c:v>1.018181818181822</c:v>
                </c:pt>
                <c:pt idx="2">
                  <c:v>1.037229437229443</c:v>
                </c:pt>
                <c:pt idx="3">
                  <c:v>1.0</c:v>
                </c:pt>
                <c:pt idx="4">
                  <c:v>0.777056277056292</c:v>
                </c:pt>
                <c:pt idx="5">
                  <c:v>0.814718614718615</c:v>
                </c:pt>
                <c:pt idx="6">
                  <c:v>0.87835497835499</c:v>
                </c:pt>
              </c:numCache>
            </c:numRef>
          </c:xVal>
          <c:yVal>
            <c:numRef>
              <c:f>'[Corrélations.xlsx]Feuil1'!$O$36:$O$42</c:f>
              <c:numCache>
                <c:formatCode>General</c:formatCode>
                <c:ptCount val="7"/>
                <c:pt idx="0">
                  <c:v>1.143176345079252</c:v>
                </c:pt>
                <c:pt idx="1">
                  <c:v>0.996964304474022</c:v>
                </c:pt>
                <c:pt idx="2">
                  <c:v>0.868008469630948</c:v>
                </c:pt>
                <c:pt idx="3">
                  <c:v>1.0</c:v>
                </c:pt>
                <c:pt idx="4">
                  <c:v>1.354073073110006</c:v>
                </c:pt>
                <c:pt idx="5">
                  <c:v>1.170192051291</c:v>
                </c:pt>
                <c:pt idx="6">
                  <c:v>1.028233296133678</c:v>
                </c:pt>
              </c:numCache>
            </c:numRef>
          </c:yVal>
          <c:smooth val="0"/>
        </c:ser>
        <c:ser>
          <c:idx val="1"/>
          <c:order val="1"/>
          <c:tx>
            <c:v>Treatments</c:v>
          </c:tx>
          <c:spPr>
            <a:ln w="19050">
              <a:noFill/>
            </a:ln>
          </c:spPr>
          <c:marker>
            <c:symbol val="circle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rrélations.xlsx]Feuil1'!$AA$39:$AA$41</c:f>
                <c:numCache>
                  <c:formatCode>General</c:formatCode>
                  <c:ptCount val="3"/>
                  <c:pt idx="0">
                    <c:v>0.0403812225198166</c:v>
                  </c:pt>
                  <c:pt idx="1">
                    <c:v>0.0572425437803966</c:v>
                  </c:pt>
                  <c:pt idx="2">
                    <c:v>0.0561518591186643</c:v>
                  </c:pt>
                </c:numCache>
              </c:numRef>
            </c:plus>
            <c:minus>
              <c:numRef>
                <c:f>'[Corrélations.xlsx]Feuil1'!$AA$39:$AA$41</c:f>
                <c:numCache>
                  <c:formatCode>General</c:formatCode>
                  <c:ptCount val="3"/>
                  <c:pt idx="0">
                    <c:v>0.0403812225198166</c:v>
                  </c:pt>
                  <c:pt idx="1">
                    <c:v>0.0572425437803966</c:v>
                  </c:pt>
                  <c:pt idx="2">
                    <c:v>0.0561518591186643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[Corrélations.xlsx]Feuil1'!$AE$39:$AE$41</c:f>
                <c:numCache>
                  <c:formatCode>General</c:formatCode>
                  <c:ptCount val="3"/>
                  <c:pt idx="0">
                    <c:v>0.0452313579110244</c:v>
                  </c:pt>
                  <c:pt idx="1">
                    <c:v>0.0336731251026318</c:v>
                  </c:pt>
                  <c:pt idx="2">
                    <c:v>0.0671336983878986</c:v>
                  </c:pt>
                </c:numCache>
              </c:numRef>
            </c:plus>
            <c:minus>
              <c:numRef>
                <c:f>'[Corrélations.xlsx]Feuil1'!$AE$39:$AE$41</c:f>
                <c:numCache>
                  <c:formatCode>General</c:formatCode>
                  <c:ptCount val="3"/>
                  <c:pt idx="0">
                    <c:v>0.0452313579110244</c:v>
                  </c:pt>
                  <c:pt idx="1">
                    <c:v>0.0336731251026318</c:v>
                  </c:pt>
                  <c:pt idx="2">
                    <c:v>0.0671336983878986</c:v>
                  </c:pt>
                </c:numCache>
              </c:numRef>
            </c:minus>
          </c:errBars>
          <c:xVal>
            <c:numRef>
              <c:f>'[Corrélations.xlsx]Feuil1'!$Z$39:$Z$41</c:f>
              <c:numCache>
                <c:formatCode>General</c:formatCode>
                <c:ptCount val="3"/>
                <c:pt idx="0">
                  <c:v>1.0</c:v>
                </c:pt>
                <c:pt idx="1">
                  <c:v>1.050800171201297</c:v>
                </c:pt>
                <c:pt idx="2">
                  <c:v>1.058762729241911</c:v>
                </c:pt>
              </c:numCache>
            </c:numRef>
          </c:xVal>
          <c:yVal>
            <c:numRef>
              <c:f>'[Corrélations.xlsx]Feuil1'!$AD$39:$AD$41</c:f>
              <c:numCache>
                <c:formatCode>General</c:formatCode>
                <c:ptCount val="3"/>
                <c:pt idx="0">
                  <c:v>1.0</c:v>
                </c:pt>
                <c:pt idx="1">
                  <c:v>0.922585227272728</c:v>
                </c:pt>
                <c:pt idx="2">
                  <c:v>1.1111505681818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620014720"/>
        <c:axId val="-786209568"/>
      </c:scatterChart>
      <c:valAx>
        <c:axId val="-620014720"/>
        <c:scaling>
          <c:orientation val="minMax"/>
          <c:max val="1.2"/>
          <c:min val="0.6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en-GB" sz="1000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sz="1000" noProof="1">
                    <a:latin typeface="Times New Roman" charset="0"/>
                    <a:ea typeface="Times New Roman" charset="0"/>
                    <a:cs typeface="Times New Roman" charset="0"/>
                  </a:rPr>
                  <a:t>Root DW </a:t>
                </a:r>
                <a:r>
                  <a:rPr lang="en-GB" sz="1000" b="0" noProof="1">
                    <a:latin typeface="Times New Roman" charset="0"/>
                    <a:ea typeface="Times New Roman" charset="0"/>
                    <a:cs typeface="Times New Roman" charset="0"/>
                  </a:rPr>
                  <a:t>(dimensionless)</a:t>
                </a:r>
              </a:p>
            </c:rich>
          </c:tx>
          <c:layout>
            <c:manualLayout>
              <c:xMode val="edge"/>
              <c:yMode val="edge"/>
              <c:x val="0.365976925985653"/>
              <c:y val="0.856831376428627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-786209568"/>
        <c:crosses val="autoZero"/>
        <c:crossBetween val="midCat"/>
        <c:majorUnit val="0.1"/>
      </c:valAx>
      <c:valAx>
        <c:axId val="-786209568"/>
        <c:scaling>
          <c:orientation val="minMax"/>
          <c:min val="0.0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sz="1000" b="1" i="0" u="none" strike="noStrike" baseline="0" noProof="1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Normalized Trp contents  in roots</a:t>
                </a:r>
                <a:endParaRPr lang="en-GB" sz="1000" b="1" i="0" u="none" strike="noStrike" baseline="0" noProof="1" smtClean="0">
                  <a:effectLst/>
                  <a:latin typeface="Times New Roman" charset="0"/>
                  <a:ea typeface="Times New Roman" charset="0"/>
                  <a:cs typeface="Times New Roman" charset="0"/>
                </a:endParaRPr>
              </a:p>
              <a:p>
                <a:pPr>
                  <a:defRPr lang="en-GB" noProof="1" dirty="0"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GB" sz="1000" b="0" i="0" u="none" strike="noStrike" baseline="0" noProof="1" smtClean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(</a:t>
                </a:r>
                <a:r>
                  <a:rPr lang="en-GB" sz="1000" b="0" i="0" u="none" strike="noStrike" baseline="0" noProof="1" smtClean="0">
                    <a:effectLst/>
                    <a:latin typeface="Times New Roman" charset="0"/>
                    <a:ea typeface="Times New Roman" charset="0"/>
                    <a:cs typeface="Times New Roman" charset="0"/>
                  </a:rPr>
                  <a:t>dimensionless</a:t>
                </a:r>
                <a:r>
                  <a:rPr lang="en-GB" sz="1000" b="0" i="0" u="none" strike="noStrike" baseline="0" noProof="1" smtClean="0">
                    <a:latin typeface="Times New Roman" charset="0"/>
                    <a:ea typeface="Times New Roman" charset="0"/>
                    <a:cs typeface="Times New Roman" charset="0"/>
                  </a:rPr>
                  <a:t>)</a:t>
                </a:r>
                <a:endParaRPr lang="en-GB" b="0" noProof="1">
                  <a:latin typeface="Times New Roman" charset="0"/>
                  <a:ea typeface="Times New Roman" charset="0"/>
                  <a:cs typeface="Times New Roman" charset="0"/>
                </a:endParaRPr>
              </a:p>
            </c:rich>
          </c:tx>
          <c:layout>
            <c:manualLayout>
              <c:xMode val="edge"/>
              <c:yMode val="edge"/>
              <c:x val="0.136915444034821"/>
              <c:y val="0.0972587424320001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-62001472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l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609590564929312"/>
          <c:y val="0.5630215881446"/>
          <c:w val="0.203060611891579"/>
          <c:h val="0.0979294848987125"/>
        </c:manualLayout>
      </c:layout>
      <c:overlay val="0"/>
      <c:txPr>
        <a:bodyPr/>
        <a:lstStyle/>
        <a:p>
          <a:pPr>
            <a:defRPr sz="800" b="1">
              <a:latin typeface="Times New Roman"/>
              <a:cs typeface="Times New Roman"/>
            </a:defRPr>
          </a:pPr>
          <a:endParaRPr lang="fr-F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7BC379-32A7-2D4C-8789-809E0CD83E5C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F3568-5268-E543-A81B-272DF85E704C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8F3568-5268-E543-A81B-272DF85E704C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65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33"/>
          <p:cNvGrpSpPr/>
          <p:nvPr/>
        </p:nvGrpSpPr>
        <p:grpSpPr>
          <a:xfrm>
            <a:off x="-59946" y="3165312"/>
            <a:ext cx="3733800" cy="2725958"/>
            <a:chOff x="-76200" y="3154123"/>
            <a:chExt cx="3733800" cy="2725958"/>
          </a:xfrm>
        </p:grpSpPr>
        <p:graphicFrame>
          <p:nvGraphicFramePr>
            <p:cNvPr id="5" name="Graphique 4"/>
            <p:cNvGraphicFramePr/>
            <p:nvPr>
              <p:extLst>
                <p:ext uri="{D42A27DB-BD31-4B8C-83A1-F6EECF244321}">
                  <p14:modId xmlns:p14="http://schemas.microsoft.com/office/powerpoint/2010/main" val="1231764377"/>
                </p:ext>
              </p:extLst>
            </p:nvPr>
          </p:nvGraphicFramePr>
          <p:xfrm>
            <a:off x="-76200" y="3154123"/>
            <a:ext cx="3733800" cy="27259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6" name="Rectangle 25"/>
            <p:cNvSpPr/>
            <p:nvPr/>
          </p:nvSpPr>
          <p:spPr>
            <a:xfrm>
              <a:off x="2590800" y="3319046"/>
              <a:ext cx="35828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altLang="fr-FR" sz="16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  <a:endParaRPr lang="fr-FR" sz="1600" dirty="0"/>
            </a:p>
          </p:txBody>
        </p:sp>
      </p:grpSp>
      <p:grpSp>
        <p:nvGrpSpPr>
          <p:cNvPr id="3" name="Grouper 32"/>
          <p:cNvGrpSpPr/>
          <p:nvPr/>
        </p:nvGrpSpPr>
        <p:grpSpPr>
          <a:xfrm>
            <a:off x="266698" y="741627"/>
            <a:ext cx="3552691" cy="2728633"/>
            <a:chOff x="266698" y="741627"/>
            <a:chExt cx="3552691" cy="2728633"/>
          </a:xfrm>
        </p:grpSpPr>
        <p:graphicFrame>
          <p:nvGraphicFramePr>
            <p:cNvPr id="6" name="Graphique 5"/>
            <p:cNvGraphicFramePr/>
            <p:nvPr>
              <p:extLst>
                <p:ext uri="{D42A27DB-BD31-4B8C-83A1-F6EECF244321}">
                  <p14:modId xmlns:p14="http://schemas.microsoft.com/office/powerpoint/2010/main" val="1963151112"/>
                </p:ext>
              </p:extLst>
            </p:nvPr>
          </p:nvGraphicFramePr>
          <p:xfrm>
            <a:off x="266698" y="741627"/>
            <a:ext cx="3552691" cy="27286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7" name="Rectangle 26"/>
            <p:cNvSpPr/>
            <p:nvPr/>
          </p:nvSpPr>
          <p:spPr>
            <a:xfrm>
              <a:off x="1066800" y="914400"/>
              <a:ext cx="35828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altLang="fr-FR" sz="16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fr-FR" sz="1600" dirty="0"/>
            </a:p>
          </p:txBody>
        </p:sp>
      </p:grpSp>
      <p:grpSp>
        <p:nvGrpSpPr>
          <p:cNvPr id="4" name="Grouper 29"/>
          <p:cNvGrpSpPr/>
          <p:nvPr/>
        </p:nvGrpSpPr>
        <p:grpSpPr>
          <a:xfrm>
            <a:off x="3050629" y="700226"/>
            <a:ext cx="3342554" cy="2770034"/>
            <a:chOff x="3515446" y="700226"/>
            <a:chExt cx="3342554" cy="2770034"/>
          </a:xfrm>
        </p:grpSpPr>
        <p:graphicFrame>
          <p:nvGraphicFramePr>
            <p:cNvPr id="22" name="Graphique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8969402"/>
                </p:ext>
              </p:extLst>
            </p:nvPr>
          </p:nvGraphicFramePr>
          <p:xfrm>
            <a:off x="3515446" y="700226"/>
            <a:ext cx="3342554" cy="27700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9" name="Rectangle 28"/>
            <p:cNvSpPr/>
            <p:nvPr/>
          </p:nvSpPr>
          <p:spPr>
            <a:xfrm>
              <a:off x="5890116" y="914400"/>
              <a:ext cx="35828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altLang="fr-FR" sz="16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fr-FR" sz="1600" dirty="0"/>
            </a:p>
          </p:txBody>
        </p:sp>
      </p:grpSp>
      <p:sp>
        <p:nvSpPr>
          <p:cNvPr id="49" name="ZoneTexte 48"/>
          <p:cNvSpPr txBox="1"/>
          <p:nvPr/>
        </p:nvSpPr>
        <p:spPr>
          <a:xfrm>
            <a:off x="5090302" y="4263279"/>
            <a:ext cx="472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Times New Roman" charset="0"/>
                <a:ea typeface="Times New Roman" charset="0"/>
                <a:cs typeface="Times New Roman" charset="0"/>
              </a:rPr>
              <a:t>AVG</a:t>
            </a:r>
            <a:r>
              <a:rPr lang="fr-FR" sz="800" b="1" dirty="0" smtClean="0">
                <a:latin typeface="Times New Roman" charset="0"/>
                <a:ea typeface="Times New Roman" charset="0"/>
                <a:cs typeface="Times New Roman" charset="0"/>
              </a:rPr>
              <a:t>  </a:t>
            </a:r>
            <a:endParaRPr lang="fr-FR" sz="8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4721906" y="3505200"/>
            <a:ext cx="793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Times New Roman" charset="0"/>
                <a:ea typeface="Times New Roman" charset="0"/>
                <a:cs typeface="Times New Roman" charset="0"/>
              </a:rPr>
              <a:t>1mM KNO</a:t>
            </a:r>
            <a:r>
              <a:rPr lang="fr-FR" sz="800" b="1" baseline="-25000" dirty="0" smtClean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endParaRPr lang="fr-FR" sz="800" b="1" baseline="-25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5105400" y="3533001"/>
            <a:ext cx="745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Times New Roman" charset="0"/>
                <a:ea typeface="Times New Roman" charset="0"/>
                <a:cs typeface="Times New Roman" charset="0"/>
              </a:rPr>
              <a:t>AVG + Glu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52" name="Connecteur droit avec flèche 51"/>
          <p:cNvCxnSpPr/>
          <p:nvPr/>
        </p:nvCxnSpPr>
        <p:spPr>
          <a:xfrm flipH="1">
            <a:off x="5334000" y="3733800"/>
            <a:ext cx="144000" cy="910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avec flèche 52"/>
          <p:cNvCxnSpPr/>
          <p:nvPr/>
        </p:nvCxnSpPr>
        <p:spPr>
          <a:xfrm rot="5400000">
            <a:off x="4998988" y="3765600"/>
            <a:ext cx="216000" cy="15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/>
          <p:cNvCxnSpPr/>
          <p:nvPr/>
        </p:nvCxnSpPr>
        <p:spPr>
          <a:xfrm rot="5400000" flipH="1" flipV="1">
            <a:off x="5184000" y="4248000"/>
            <a:ext cx="180000" cy="15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"/>
          <p:cNvSpPr txBox="1"/>
          <p:nvPr/>
        </p:nvSpPr>
        <p:spPr>
          <a:xfrm>
            <a:off x="4191000" y="8531423"/>
            <a:ext cx="2453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Le Deunff et al., 2019</a:t>
            </a:r>
          </a:p>
        </p:txBody>
      </p:sp>
      <p:sp>
        <p:nvSpPr>
          <p:cNvPr id="60" name="Rectangle 59"/>
          <p:cNvSpPr/>
          <p:nvPr/>
        </p:nvSpPr>
        <p:spPr>
          <a:xfrm>
            <a:off x="152400" y="6019800"/>
            <a:ext cx="658199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Fig. S1: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Effects of nitrate on different roots and shoots bichemical and morphological variables in </a:t>
            </a:r>
            <a:r>
              <a:rPr lang="en-US" sz="1200" i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rassica napus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eedlings treated with varying external nitrate concentrations for 5 d on agar plates. </a:t>
            </a:r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)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elationships between </a:t>
            </a:r>
            <a:r>
              <a:rPr lang="en-US" sz="1200" baseline="300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5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N accumulation in shoots and FW or shoot surface area after normalization of the values relative to 1 mM KNO</a:t>
            </a:r>
            <a:r>
              <a:rPr lang="en-US" sz="1200" baseline="-250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control). </a:t>
            </a:r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)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elationship between shoots Trp content and </a:t>
            </a:r>
            <a:r>
              <a:rPr lang="en-US" sz="1200" baseline="300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5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N accumulation after normalization of the values relative to 1 mM KNO</a:t>
            </a:r>
            <a:r>
              <a:rPr lang="en-US" sz="1200" baseline="-250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control). </a:t>
            </a:r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) 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elationship between the roots Trp content and the root DW. </a:t>
            </a:r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Same relationship as in C but the values have been normalized relative to 1mM KNO</a:t>
            </a:r>
            <a:r>
              <a:rPr lang="en-US" sz="1200" baseline="-250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(control).</a:t>
            </a:r>
            <a:r>
              <a:rPr lang="en-US" sz="1200" noProof="1" smtClean="0"/>
              <a:t> </a:t>
            </a:r>
            <a:r>
              <a:rPr lang="en-US" sz="1200" noProof="1" smtClean="0">
                <a:latin typeface="Times New Roman"/>
                <a:cs typeface="Times New Roman"/>
              </a:rPr>
              <a:t>Values are the average (± SE) of four repeats of four seedlings each.</a:t>
            </a:r>
            <a:r>
              <a:rPr lang="en-US" sz="1200" noProof="1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ed points correspond to estimation of the values of the same variables in an other experiment for seedlings treated with 1mM KNO</a:t>
            </a:r>
            <a:r>
              <a:rPr lang="en-US" sz="1200" baseline="-25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,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10 </a:t>
            </a:r>
            <a:r>
              <a:rPr lang="en-US" sz="1200" dirty="0" err="1" smtClean="0">
                <a:solidFill>
                  <a:srgbClr val="000000"/>
                </a:solidFill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AVG + 1 </a:t>
            </a:r>
            <a:r>
              <a:rPr 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KNO</a:t>
            </a:r>
            <a:r>
              <a:rPr lang="en-US" sz="1200" baseline="-25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and 10 </a:t>
            </a:r>
            <a:r>
              <a:rPr lang="en-US" sz="1200" dirty="0" err="1" smtClean="0">
                <a:solidFill>
                  <a:srgbClr val="000000"/>
                </a:solidFill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AVG + 1mM </a:t>
            </a:r>
            <a:r>
              <a:rPr 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Glu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+ 1 </a:t>
            </a:r>
            <a:r>
              <a:rPr 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KNO</a:t>
            </a:r>
            <a:r>
              <a:rPr lang="en-US" sz="1200" baseline="-25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200" noProof="1" smtClean="0">
                <a:latin typeface="Times New Roman"/>
                <a:cs typeface="Times New Roman"/>
              </a:rPr>
              <a:t> </a:t>
            </a:r>
            <a:endParaRPr lang="en-US" sz="1200" dirty="0" smtClean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5364434"/>
              </p:ext>
            </p:extLst>
          </p:nvPr>
        </p:nvGraphicFramePr>
        <p:xfrm>
          <a:off x="2667000" y="2996824"/>
          <a:ext cx="3726183" cy="2765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8" name="Rectangle 27"/>
          <p:cNvSpPr/>
          <p:nvPr/>
        </p:nvSpPr>
        <p:spPr>
          <a:xfrm>
            <a:off x="5425299" y="3327665"/>
            <a:ext cx="35828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altLang="fr-FR" sz="16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</a:t>
            </a:r>
            <a:endParaRPr lang="fr-FR" sz="1600" dirty="0"/>
          </a:p>
        </p:txBody>
      </p:sp>
      <p:sp>
        <p:nvSpPr>
          <p:cNvPr id="62" name="Rectangle 61"/>
          <p:cNvSpPr/>
          <p:nvPr/>
        </p:nvSpPr>
        <p:spPr>
          <a:xfrm>
            <a:off x="1563074" y="852101"/>
            <a:ext cx="6208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hoots</a:t>
            </a:r>
            <a:endParaRPr lang="fr-FR" sz="1200" b="1" dirty="0"/>
          </a:p>
        </p:txBody>
      </p:sp>
      <p:sp>
        <p:nvSpPr>
          <p:cNvPr id="63" name="Rectangle 62"/>
          <p:cNvSpPr/>
          <p:nvPr/>
        </p:nvSpPr>
        <p:spPr>
          <a:xfrm>
            <a:off x="4530091" y="866001"/>
            <a:ext cx="5608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oots</a:t>
            </a:r>
            <a:endParaRPr lang="fr-FR" sz="1200" b="1" dirty="0"/>
          </a:p>
        </p:txBody>
      </p:sp>
      <p:sp>
        <p:nvSpPr>
          <p:cNvPr id="64" name="Rectangle 63"/>
          <p:cNvSpPr/>
          <p:nvPr/>
        </p:nvSpPr>
        <p:spPr>
          <a:xfrm>
            <a:off x="4546961" y="3276600"/>
            <a:ext cx="5608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oots</a:t>
            </a:r>
            <a:endParaRPr lang="fr-FR" sz="1200" b="1" dirty="0"/>
          </a:p>
        </p:txBody>
      </p:sp>
      <p:grpSp>
        <p:nvGrpSpPr>
          <p:cNvPr id="8" name="Grouper 7"/>
          <p:cNvGrpSpPr/>
          <p:nvPr/>
        </p:nvGrpSpPr>
        <p:grpSpPr>
          <a:xfrm>
            <a:off x="836712" y="866001"/>
            <a:ext cx="462981" cy="1800000"/>
            <a:chOff x="805779" y="866001"/>
            <a:chExt cx="462981" cy="1800000"/>
          </a:xfrm>
        </p:grpSpPr>
        <p:sp>
          <p:nvSpPr>
            <p:cNvPr id="33" name="Rectangle 25"/>
            <p:cNvSpPr>
              <a:spLocks noChangeArrowheads="1"/>
            </p:cNvSpPr>
            <p:nvPr/>
          </p:nvSpPr>
          <p:spPr bwMode="auto">
            <a:xfrm>
              <a:off x="916608" y="2550946"/>
              <a:ext cx="64120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4" name="Rectangle 25"/>
            <p:cNvSpPr>
              <a:spLocks noChangeArrowheads="1"/>
            </p:cNvSpPr>
            <p:nvPr/>
          </p:nvSpPr>
          <p:spPr bwMode="auto">
            <a:xfrm flipH="1">
              <a:off x="901789" y="2129708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" name="Rectangle 25"/>
            <p:cNvSpPr>
              <a:spLocks noChangeArrowheads="1"/>
            </p:cNvSpPr>
            <p:nvPr/>
          </p:nvSpPr>
          <p:spPr bwMode="auto">
            <a:xfrm flipH="1">
              <a:off x="805779" y="1076619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2" name="Rectangle 25"/>
            <p:cNvSpPr>
              <a:spLocks noChangeArrowheads="1"/>
            </p:cNvSpPr>
            <p:nvPr/>
          </p:nvSpPr>
          <p:spPr bwMode="auto">
            <a:xfrm flipH="1">
              <a:off x="805779" y="2340326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3" name="Rectangle 25"/>
            <p:cNvSpPr>
              <a:spLocks noChangeArrowheads="1"/>
            </p:cNvSpPr>
            <p:nvPr/>
          </p:nvSpPr>
          <p:spPr bwMode="auto">
            <a:xfrm flipH="1">
              <a:off x="908669" y="1287237"/>
              <a:ext cx="168069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4" name="Rectangle 25"/>
            <p:cNvSpPr>
              <a:spLocks noChangeArrowheads="1"/>
            </p:cNvSpPr>
            <p:nvPr/>
          </p:nvSpPr>
          <p:spPr bwMode="auto">
            <a:xfrm flipH="1">
              <a:off x="901789" y="866001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4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5" name="Rectangle 25"/>
            <p:cNvSpPr>
              <a:spLocks noChangeArrowheads="1"/>
            </p:cNvSpPr>
            <p:nvPr/>
          </p:nvSpPr>
          <p:spPr bwMode="auto">
            <a:xfrm flipH="1">
              <a:off x="805779" y="1919090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6" name="Rectangle 25"/>
            <p:cNvSpPr>
              <a:spLocks noChangeArrowheads="1"/>
            </p:cNvSpPr>
            <p:nvPr/>
          </p:nvSpPr>
          <p:spPr bwMode="auto">
            <a:xfrm flipH="1">
              <a:off x="805779" y="1497855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47" name="Rectangle 25"/>
            <p:cNvSpPr>
              <a:spLocks noChangeArrowheads="1"/>
            </p:cNvSpPr>
            <p:nvPr/>
          </p:nvSpPr>
          <p:spPr bwMode="auto">
            <a:xfrm flipH="1">
              <a:off x="901789" y="1708472"/>
              <a:ext cx="366971" cy="115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48" name="Grouper 47"/>
          <p:cNvGrpSpPr/>
          <p:nvPr/>
        </p:nvGrpSpPr>
        <p:grpSpPr>
          <a:xfrm>
            <a:off x="1026776" y="928800"/>
            <a:ext cx="50400" cy="1713384"/>
            <a:chOff x="685871" y="467544"/>
            <a:chExt cx="45719" cy="2592288"/>
          </a:xfrm>
        </p:grpSpPr>
        <p:cxnSp>
          <p:nvCxnSpPr>
            <p:cNvPr id="55" name="Connecteur droit 54"/>
            <p:cNvCxnSpPr/>
            <p:nvPr/>
          </p:nvCxnSpPr>
          <p:spPr>
            <a:xfrm>
              <a:off x="685871" y="3057983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55"/>
            <p:cNvCxnSpPr/>
            <p:nvPr/>
          </p:nvCxnSpPr>
          <p:spPr>
            <a:xfrm>
              <a:off x="685871" y="2410374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685871" y="1438959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57"/>
            <p:cNvCxnSpPr/>
            <p:nvPr/>
          </p:nvCxnSpPr>
          <p:spPr>
            <a:xfrm>
              <a:off x="685871" y="791349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cteur droit 64"/>
            <p:cNvCxnSpPr/>
            <p:nvPr/>
          </p:nvCxnSpPr>
          <p:spPr>
            <a:xfrm>
              <a:off x="685871" y="1762764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cteur droit 65"/>
            <p:cNvCxnSpPr/>
            <p:nvPr/>
          </p:nvCxnSpPr>
          <p:spPr>
            <a:xfrm>
              <a:off x="685871" y="1115154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cteur droit 66"/>
            <p:cNvCxnSpPr/>
            <p:nvPr/>
          </p:nvCxnSpPr>
          <p:spPr>
            <a:xfrm>
              <a:off x="685871" y="2734179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67"/>
            <p:cNvCxnSpPr/>
            <p:nvPr/>
          </p:nvCxnSpPr>
          <p:spPr>
            <a:xfrm>
              <a:off x="685871" y="2086569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68"/>
            <p:cNvCxnSpPr/>
            <p:nvPr/>
          </p:nvCxnSpPr>
          <p:spPr>
            <a:xfrm>
              <a:off x="685871" y="467544"/>
              <a:ext cx="45719" cy="1849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ouper 69"/>
          <p:cNvGrpSpPr/>
          <p:nvPr/>
        </p:nvGrpSpPr>
        <p:grpSpPr>
          <a:xfrm>
            <a:off x="1052736" y="2754543"/>
            <a:ext cx="1944000" cy="161273"/>
            <a:chOff x="1422090" y="5735258"/>
            <a:chExt cx="1679680" cy="153888"/>
          </a:xfrm>
        </p:grpSpPr>
        <p:sp>
          <p:nvSpPr>
            <p:cNvPr id="71" name="Rectangle 25"/>
            <p:cNvSpPr>
              <a:spLocks noChangeArrowheads="1"/>
            </p:cNvSpPr>
            <p:nvPr/>
          </p:nvSpPr>
          <p:spPr bwMode="auto">
            <a:xfrm>
              <a:off x="1825980" y="573525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72" name="Rectangle 25"/>
            <p:cNvSpPr>
              <a:spLocks noChangeArrowheads="1"/>
            </p:cNvSpPr>
            <p:nvPr/>
          </p:nvSpPr>
          <p:spPr bwMode="auto">
            <a:xfrm>
              <a:off x="1422090" y="573525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73" name="Rectangle 25"/>
            <p:cNvSpPr>
              <a:spLocks noChangeArrowheads="1"/>
            </p:cNvSpPr>
            <p:nvPr/>
          </p:nvSpPr>
          <p:spPr bwMode="auto">
            <a:xfrm>
              <a:off x="2229870" y="573525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000" b="1" dirty="0">
                  <a:solidFill>
                    <a:srgbClr val="000000"/>
                  </a:solidFill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74" name="Rectangle 25"/>
            <p:cNvSpPr>
              <a:spLocks noChangeArrowheads="1"/>
            </p:cNvSpPr>
            <p:nvPr/>
          </p:nvSpPr>
          <p:spPr bwMode="auto">
            <a:xfrm>
              <a:off x="3037650" y="573525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75" name="Rectangle 25"/>
            <p:cNvSpPr>
              <a:spLocks noChangeArrowheads="1"/>
            </p:cNvSpPr>
            <p:nvPr/>
          </p:nvSpPr>
          <p:spPr bwMode="auto">
            <a:xfrm>
              <a:off x="2633760" y="573525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76" name="Grouper 75"/>
          <p:cNvGrpSpPr/>
          <p:nvPr/>
        </p:nvGrpSpPr>
        <p:grpSpPr>
          <a:xfrm>
            <a:off x="1072860" y="2642400"/>
            <a:ext cx="1872574" cy="50400"/>
            <a:chOff x="1442214" y="5624155"/>
            <a:chExt cx="1507088" cy="50400"/>
          </a:xfrm>
        </p:grpSpPr>
        <p:cxnSp>
          <p:nvCxnSpPr>
            <p:cNvPr id="77" name="Connecteur droit 76"/>
            <p:cNvCxnSpPr/>
            <p:nvPr/>
          </p:nvCxnSpPr>
          <p:spPr>
            <a:xfrm rot="5400000">
              <a:off x="1794315" y="564829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77"/>
            <p:cNvCxnSpPr/>
            <p:nvPr/>
          </p:nvCxnSpPr>
          <p:spPr>
            <a:xfrm rot="5400000">
              <a:off x="2923044" y="564829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78"/>
            <p:cNvCxnSpPr/>
            <p:nvPr/>
          </p:nvCxnSpPr>
          <p:spPr>
            <a:xfrm rot="5400000">
              <a:off x="2546801" y="564829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 rot="5400000">
              <a:off x="1418072" y="564829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80"/>
            <p:cNvCxnSpPr/>
            <p:nvPr/>
          </p:nvCxnSpPr>
          <p:spPr>
            <a:xfrm rot="5400000">
              <a:off x="2170558" y="564829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ZoneTexte 35"/>
          <p:cNvSpPr txBox="1"/>
          <p:nvPr/>
        </p:nvSpPr>
        <p:spPr>
          <a:xfrm>
            <a:off x="2390996" y="4258063"/>
            <a:ext cx="731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Times New Roman" charset="0"/>
                <a:ea typeface="Times New Roman" charset="0"/>
                <a:cs typeface="Times New Roman" charset="0"/>
              </a:rPr>
              <a:t>AVG + Glu 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2059297" y="4049789"/>
            <a:ext cx="793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Times New Roman" charset="0"/>
                <a:ea typeface="Times New Roman" charset="0"/>
                <a:cs typeface="Times New Roman" charset="0"/>
              </a:rPr>
              <a:t>1mM KNO</a:t>
            </a:r>
            <a:r>
              <a:rPr lang="fr-FR" sz="800" b="1" baseline="-25000" dirty="0" smtClean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endParaRPr lang="fr-FR" sz="800" b="1" baseline="-25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2187827" y="4735589"/>
            <a:ext cx="4192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Times New Roman" charset="0"/>
                <a:ea typeface="Times New Roman" charset="0"/>
                <a:cs typeface="Times New Roman" charset="0"/>
              </a:rPr>
              <a:t>AV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39" name="Connecteur droit avec flèche 38"/>
          <p:cNvCxnSpPr/>
          <p:nvPr/>
        </p:nvCxnSpPr>
        <p:spPr>
          <a:xfrm rot="5400000" flipH="1" flipV="1">
            <a:off x="2284254" y="4734795"/>
            <a:ext cx="215072" cy="15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avec flèche 39"/>
          <p:cNvCxnSpPr/>
          <p:nvPr/>
        </p:nvCxnSpPr>
        <p:spPr>
          <a:xfrm rot="16200000" flipH="1">
            <a:off x="2257307" y="4292189"/>
            <a:ext cx="18000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/>
          <p:nvPr/>
        </p:nvCxnSpPr>
        <p:spPr>
          <a:xfrm rot="10800000" flipV="1">
            <a:off x="2554254" y="4430789"/>
            <a:ext cx="152402" cy="975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tangle 60"/>
          <p:cNvSpPr/>
          <p:nvPr/>
        </p:nvSpPr>
        <p:spPr>
          <a:xfrm>
            <a:off x="1579328" y="3287789"/>
            <a:ext cx="6208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noProof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hoots</a:t>
            </a:r>
            <a:endParaRPr lang="fr-FR" sz="1200" b="1" dirty="0"/>
          </a:p>
        </p:txBody>
      </p:sp>
      <p:grpSp>
        <p:nvGrpSpPr>
          <p:cNvPr id="9" name="Grouper 8"/>
          <p:cNvGrpSpPr/>
          <p:nvPr/>
        </p:nvGrpSpPr>
        <p:grpSpPr>
          <a:xfrm>
            <a:off x="826254" y="3272789"/>
            <a:ext cx="483560" cy="1834075"/>
            <a:chOff x="791708" y="3250970"/>
            <a:chExt cx="483560" cy="1834075"/>
          </a:xfrm>
        </p:grpSpPr>
        <p:sp>
          <p:nvSpPr>
            <p:cNvPr id="83" name="Rectangle 25"/>
            <p:cNvSpPr>
              <a:spLocks noChangeArrowheads="1"/>
            </p:cNvSpPr>
            <p:nvPr/>
          </p:nvSpPr>
          <p:spPr bwMode="auto">
            <a:xfrm>
              <a:off x="901789" y="4931157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4" name="Rectangle 25"/>
            <p:cNvSpPr>
              <a:spLocks noChangeArrowheads="1"/>
            </p:cNvSpPr>
            <p:nvPr/>
          </p:nvSpPr>
          <p:spPr bwMode="auto">
            <a:xfrm flipH="1">
              <a:off x="901789" y="4371094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5" name="Rectangle 25"/>
            <p:cNvSpPr>
              <a:spLocks noChangeArrowheads="1"/>
            </p:cNvSpPr>
            <p:nvPr/>
          </p:nvSpPr>
          <p:spPr bwMode="auto">
            <a:xfrm flipH="1">
              <a:off x="791708" y="4651125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6" name="Rectangle 25"/>
            <p:cNvSpPr>
              <a:spLocks noChangeArrowheads="1"/>
            </p:cNvSpPr>
            <p:nvPr/>
          </p:nvSpPr>
          <p:spPr bwMode="auto">
            <a:xfrm flipH="1">
              <a:off x="908297" y="3250970"/>
              <a:ext cx="1680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7" name="Rectangle 25"/>
            <p:cNvSpPr>
              <a:spLocks noChangeArrowheads="1"/>
            </p:cNvSpPr>
            <p:nvPr/>
          </p:nvSpPr>
          <p:spPr bwMode="auto">
            <a:xfrm flipH="1">
              <a:off x="791708" y="4091063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8" name="Rectangle 25"/>
            <p:cNvSpPr>
              <a:spLocks noChangeArrowheads="1"/>
            </p:cNvSpPr>
            <p:nvPr/>
          </p:nvSpPr>
          <p:spPr bwMode="auto">
            <a:xfrm flipH="1">
              <a:off x="791708" y="3531001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89" name="Rectangle 25"/>
            <p:cNvSpPr>
              <a:spLocks noChangeArrowheads="1"/>
            </p:cNvSpPr>
            <p:nvPr/>
          </p:nvSpPr>
          <p:spPr bwMode="auto">
            <a:xfrm flipH="1">
              <a:off x="908297" y="3811032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90" name="Grouper 89"/>
          <p:cNvGrpSpPr/>
          <p:nvPr/>
        </p:nvGrpSpPr>
        <p:grpSpPr>
          <a:xfrm flipH="1">
            <a:off x="1031454" y="3330389"/>
            <a:ext cx="50400" cy="1728000"/>
            <a:chOff x="1624080" y="843787"/>
            <a:chExt cx="50400" cy="2259574"/>
          </a:xfrm>
        </p:grpSpPr>
        <p:cxnSp>
          <p:nvCxnSpPr>
            <p:cNvPr id="91" name="Connecteur droit 90"/>
            <p:cNvCxnSpPr/>
            <p:nvPr/>
          </p:nvCxnSpPr>
          <p:spPr>
            <a:xfrm>
              <a:off x="1624080" y="3101245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cteur droit 91"/>
            <p:cNvCxnSpPr/>
            <p:nvPr/>
          </p:nvCxnSpPr>
          <p:spPr>
            <a:xfrm>
              <a:off x="1624080" y="2348759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cteur droit 92"/>
            <p:cNvCxnSpPr/>
            <p:nvPr/>
          </p:nvCxnSpPr>
          <p:spPr>
            <a:xfrm>
              <a:off x="1624080" y="1220030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cteur droit 93"/>
            <p:cNvCxnSpPr/>
            <p:nvPr/>
          </p:nvCxnSpPr>
          <p:spPr>
            <a:xfrm>
              <a:off x="1624080" y="15962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cteur droit 94"/>
            <p:cNvCxnSpPr/>
            <p:nvPr/>
          </p:nvCxnSpPr>
          <p:spPr>
            <a:xfrm>
              <a:off x="1624080" y="84378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cteur droit 95"/>
            <p:cNvCxnSpPr/>
            <p:nvPr/>
          </p:nvCxnSpPr>
          <p:spPr>
            <a:xfrm>
              <a:off x="1624080" y="2725002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cteur droit 96"/>
            <p:cNvCxnSpPr/>
            <p:nvPr/>
          </p:nvCxnSpPr>
          <p:spPr>
            <a:xfrm>
              <a:off x="1624080" y="1972516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Grouper 97"/>
          <p:cNvGrpSpPr/>
          <p:nvPr/>
        </p:nvGrpSpPr>
        <p:grpSpPr>
          <a:xfrm>
            <a:off x="1015083" y="5120782"/>
            <a:ext cx="2051800" cy="196554"/>
            <a:chOff x="1409020" y="6388294"/>
            <a:chExt cx="1339910" cy="153888"/>
          </a:xfrm>
        </p:grpSpPr>
        <p:sp>
          <p:nvSpPr>
            <p:cNvPr id="99" name="Rectangle 25"/>
            <p:cNvSpPr>
              <a:spLocks noChangeArrowheads="1"/>
            </p:cNvSpPr>
            <p:nvPr/>
          </p:nvSpPr>
          <p:spPr bwMode="auto">
            <a:xfrm>
              <a:off x="1812910" y="638829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00" name="Rectangle 25"/>
            <p:cNvSpPr>
              <a:spLocks noChangeArrowheads="1"/>
            </p:cNvSpPr>
            <p:nvPr/>
          </p:nvSpPr>
          <p:spPr bwMode="auto">
            <a:xfrm>
              <a:off x="1409020" y="6388294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0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01" name="Rectangle 25"/>
            <p:cNvSpPr>
              <a:spLocks noChangeArrowheads="1"/>
            </p:cNvSpPr>
            <p:nvPr/>
          </p:nvSpPr>
          <p:spPr bwMode="auto">
            <a:xfrm>
              <a:off x="2216800" y="6388294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02" name="Rectangle 25"/>
            <p:cNvSpPr>
              <a:spLocks noChangeArrowheads="1"/>
            </p:cNvSpPr>
            <p:nvPr/>
          </p:nvSpPr>
          <p:spPr bwMode="auto">
            <a:xfrm>
              <a:off x="2620690" y="6388294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103" name="Grouper 102"/>
          <p:cNvGrpSpPr/>
          <p:nvPr/>
        </p:nvGrpSpPr>
        <p:grpSpPr>
          <a:xfrm>
            <a:off x="1089114" y="5054789"/>
            <a:ext cx="1879200" cy="50400"/>
            <a:chOff x="1556792" y="6372200"/>
            <a:chExt cx="1130845" cy="50400"/>
          </a:xfrm>
        </p:grpSpPr>
        <p:cxnSp>
          <p:nvCxnSpPr>
            <p:cNvPr id="104" name="Connecteur droit 103"/>
            <p:cNvCxnSpPr/>
            <p:nvPr/>
          </p:nvCxnSpPr>
          <p:spPr>
            <a:xfrm rot="5400000">
              <a:off x="1908893" y="6396342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cteur droit 104"/>
            <p:cNvCxnSpPr/>
            <p:nvPr/>
          </p:nvCxnSpPr>
          <p:spPr>
            <a:xfrm rot="5400000">
              <a:off x="1532650" y="6396342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cteur droit 105"/>
            <p:cNvCxnSpPr/>
            <p:nvPr/>
          </p:nvCxnSpPr>
          <p:spPr>
            <a:xfrm rot="5400000">
              <a:off x="2285136" y="6396342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cteur droit 106"/>
            <p:cNvCxnSpPr/>
            <p:nvPr/>
          </p:nvCxnSpPr>
          <p:spPr>
            <a:xfrm rot="5400000">
              <a:off x="2661379" y="6396342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er 107"/>
          <p:cNvGrpSpPr/>
          <p:nvPr/>
        </p:nvGrpSpPr>
        <p:grpSpPr>
          <a:xfrm>
            <a:off x="3733800" y="5139968"/>
            <a:ext cx="2106000" cy="153888"/>
            <a:chOff x="1815660" y="6053254"/>
            <a:chExt cx="2479379" cy="153888"/>
          </a:xfrm>
        </p:grpSpPr>
        <p:sp>
          <p:nvSpPr>
            <p:cNvPr id="109" name="Rectangle 25"/>
            <p:cNvSpPr>
              <a:spLocks noChangeArrowheads="1"/>
            </p:cNvSpPr>
            <p:nvPr/>
          </p:nvSpPr>
          <p:spPr bwMode="auto">
            <a:xfrm>
              <a:off x="1815660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6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0" name="Rectangle 25"/>
            <p:cNvSpPr>
              <a:spLocks noChangeArrowheads="1"/>
            </p:cNvSpPr>
            <p:nvPr/>
          </p:nvSpPr>
          <p:spPr bwMode="auto">
            <a:xfrm>
              <a:off x="3730849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1" name="Rectangle 25"/>
            <p:cNvSpPr>
              <a:spLocks noChangeArrowheads="1"/>
            </p:cNvSpPr>
            <p:nvPr/>
          </p:nvSpPr>
          <p:spPr bwMode="auto">
            <a:xfrm>
              <a:off x="3431220" y="6053254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2" name="Rectangle 25"/>
            <p:cNvSpPr>
              <a:spLocks noChangeArrowheads="1"/>
            </p:cNvSpPr>
            <p:nvPr/>
          </p:nvSpPr>
          <p:spPr bwMode="auto">
            <a:xfrm>
              <a:off x="4134739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3" name="Rectangle 25"/>
            <p:cNvSpPr>
              <a:spLocks noChangeArrowheads="1"/>
            </p:cNvSpPr>
            <p:nvPr/>
          </p:nvSpPr>
          <p:spPr bwMode="auto">
            <a:xfrm>
              <a:off x="2219550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7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4" name="Rectangle 25"/>
            <p:cNvSpPr>
              <a:spLocks noChangeArrowheads="1"/>
            </p:cNvSpPr>
            <p:nvPr/>
          </p:nvSpPr>
          <p:spPr bwMode="auto">
            <a:xfrm>
              <a:off x="3027330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9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15" name="Rectangle 25"/>
            <p:cNvSpPr>
              <a:spLocks noChangeArrowheads="1"/>
            </p:cNvSpPr>
            <p:nvPr/>
          </p:nvSpPr>
          <p:spPr bwMode="auto">
            <a:xfrm>
              <a:off x="2623440" y="605325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8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116" name="Grouper 115"/>
          <p:cNvGrpSpPr/>
          <p:nvPr/>
        </p:nvGrpSpPr>
        <p:grpSpPr>
          <a:xfrm>
            <a:off x="3794400" y="5063829"/>
            <a:ext cx="1972800" cy="50400"/>
            <a:chOff x="1852118" y="6008662"/>
            <a:chExt cx="2259574" cy="50400"/>
          </a:xfrm>
        </p:grpSpPr>
        <p:cxnSp>
          <p:nvCxnSpPr>
            <p:cNvPr id="117" name="Connecteur droit 116"/>
            <p:cNvCxnSpPr/>
            <p:nvPr/>
          </p:nvCxnSpPr>
          <p:spPr>
            <a:xfrm rot="5400000">
              <a:off x="2204219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cteur droit 117"/>
            <p:cNvCxnSpPr/>
            <p:nvPr/>
          </p:nvCxnSpPr>
          <p:spPr>
            <a:xfrm rot="5400000">
              <a:off x="3332948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118"/>
            <p:cNvCxnSpPr/>
            <p:nvPr/>
          </p:nvCxnSpPr>
          <p:spPr>
            <a:xfrm rot="5400000">
              <a:off x="4085434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cteur droit 119"/>
            <p:cNvCxnSpPr/>
            <p:nvPr/>
          </p:nvCxnSpPr>
          <p:spPr>
            <a:xfrm rot="5400000">
              <a:off x="2956705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cteur droit 120"/>
            <p:cNvCxnSpPr/>
            <p:nvPr/>
          </p:nvCxnSpPr>
          <p:spPr>
            <a:xfrm rot="5400000">
              <a:off x="3709191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cteur droit 121"/>
            <p:cNvCxnSpPr/>
            <p:nvPr/>
          </p:nvCxnSpPr>
          <p:spPr>
            <a:xfrm rot="5400000">
              <a:off x="1827976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cteur droit 122"/>
            <p:cNvCxnSpPr/>
            <p:nvPr/>
          </p:nvCxnSpPr>
          <p:spPr>
            <a:xfrm rot="5400000">
              <a:off x="2580462" y="60328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er 10"/>
          <p:cNvGrpSpPr/>
          <p:nvPr/>
        </p:nvGrpSpPr>
        <p:grpSpPr>
          <a:xfrm>
            <a:off x="3546000" y="3261600"/>
            <a:ext cx="471293" cy="1839363"/>
            <a:chOff x="3495526" y="3261600"/>
            <a:chExt cx="471293" cy="1839363"/>
          </a:xfrm>
        </p:grpSpPr>
        <p:sp>
          <p:nvSpPr>
            <p:cNvPr id="125" name="Rectangle 25"/>
            <p:cNvSpPr>
              <a:spLocks noChangeArrowheads="1"/>
            </p:cNvSpPr>
            <p:nvPr/>
          </p:nvSpPr>
          <p:spPr bwMode="auto">
            <a:xfrm>
              <a:off x="3600000" y="4983111"/>
              <a:ext cx="258341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26" name="Rectangle 25"/>
            <p:cNvSpPr>
              <a:spLocks noChangeArrowheads="1"/>
            </p:cNvSpPr>
            <p:nvPr/>
          </p:nvSpPr>
          <p:spPr bwMode="auto">
            <a:xfrm flipH="1">
              <a:off x="3495528" y="4548340"/>
              <a:ext cx="425217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4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27" name="Rectangle 25"/>
            <p:cNvSpPr>
              <a:spLocks noChangeArrowheads="1"/>
            </p:cNvSpPr>
            <p:nvPr/>
          </p:nvSpPr>
          <p:spPr bwMode="auto">
            <a:xfrm flipH="1">
              <a:off x="3495526" y="3476057"/>
              <a:ext cx="4252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4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28" name="Rectangle 25"/>
            <p:cNvSpPr>
              <a:spLocks noChangeArrowheads="1"/>
            </p:cNvSpPr>
            <p:nvPr/>
          </p:nvSpPr>
          <p:spPr bwMode="auto">
            <a:xfrm flipH="1">
              <a:off x="3495529" y="4779242"/>
              <a:ext cx="425216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29" name="Rectangle 25"/>
            <p:cNvSpPr>
              <a:spLocks noChangeArrowheads="1"/>
            </p:cNvSpPr>
            <p:nvPr/>
          </p:nvSpPr>
          <p:spPr bwMode="auto">
            <a:xfrm flipH="1">
              <a:off x="3495526" y="3690513"/>
              <a:ext cx="4252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30" name="Rectangle 25"/>
            <p:cNvSpPr>
              <a:spLocks noChangeArrowheads="1"/>
            </p:cNvSpPr>
            <p:nvPr/>
          </p:nvSpPr>
          <p:spPr bwMode="auto">
            <a:xfrm flipH="1">
              <a:off x="3495526" y="3261600"/>
              <a:ext cx="4252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6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31" name="Rectangle 25"/>
            <p:cNvSpPr>
              <a:spLocks noChangeArrowheads="1"/>
            </p:cNvSpPr>
            <p:nvPr/>
          </p:nvSpPr>
          <p:spPr bwMode="auto">
            <a:xfrm flipH="1">
              <a:off x="3495526" y="4333883"/>
              <a:ext cx="4252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6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32" name="Rectangle 25"/>
            <p:cNvSpPr>
              <a:spLocks noChangeArrowheads="1"/>
            </p:cNvSpPr>
            <p:nvPr/>
          </p:nvSpPr>
          <p:spPr bwMode="auto">
            <a:xfrm flipH="1">
              <a:off x="3600000" y="3904970"/>
              <a:ext cx="3668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33" name="Rectangle 25"/>
            <p:cNvSpPr>
              <a:spLocks noChangeArrowheads="1"/>
            </p:cNvSpPr>
            <p:nvPr/>
          </p:nvSpPr>
          <p:spPr bwMode="auto">
            <a:xfrm flipH="1">
              <a:off x="3495526" y="4119427"/>
              <a:ext cx="425219" cy="117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8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134" name="Grouper 133"/>
          <p:cNvGrpSpPr/>
          <p:nvPr/>
        </p:nvGrpSpPr>
        <p:grpSpPr>
          <a:xfrm flipH="1">
            <a:off x="3744000" y="3340800"/>
            <a:ext cx="50400" cy="1720800"/>
            <a:chOff x="2802536" y="712277"/>
            <a:chExt cx="50400" cy="3012058"/>
          </a:xfrm>
        </p:grpSpPr>
        <p:cxnSp>
          <p:nvCxnSpPr>
            <p:cNvPr id="135" name="Connecteur droit 134"/>
            <p:cNvCxnSpPr/>
            <p:nvPr/>
          </p:nvCxnSpPr>
          <p:spPr>
            <a:xfrm>
              <a:off x="2802536" y="3722219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cteur droit 135"/>
            <p:cNvCxnSpPr/>
            <p:nvPr/>
          </p:nvCxnSpPr>
          <p:spPr>
            <a:xfrm>
              <a:off x="2802536" y="2593490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cteur droit 136"/>
            <p:cNvCxnSpPr/>
            <p:nvPr/>
          </p:nvCxnSpPr>
          <p:spPr>
            <a:xfrm>
              <a:off x="2802536" y="1841004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cteur droit 137"/>
            <p:cNvCxnSpPr/>
            <p:nvPr/>
          </p:nvCxnSpPr>
          <p:spPr>
            <a:xfrm>
              <a:off x="2802536" y="296973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cteur droit 138"/>
            <p:cNvCxnSpPr/>
            <p:nvPr/>
          </p:nvCxnSpPr>
          <p:spPr>
            <a:xfrm>
              <a:off x="2802536" y="221724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cteur droit 139"/>
            <p:cNvCxnSpPr/>
            <p:nvPr/>
          </p:nvCxnSpPr>
          <p:spPr>
            <a:xfrm>
              <a:off x="2802536" y="3345976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cteur droit 140"/>
            <p:cNvCxnSpPr/>
            <p:nvPr/>
          </p:nvCxnSpPr>
          <p:spPr>
            <a:xfrm>
              <a:off x="2802536" y="1464761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necteur droit 141"/>
            <p:cNvCxnSpPr/>
            <p:nvPr/>
          </p:nvCxnSpPr>
          <p:spPr>
            <a:xfrm>
              <a:off x="2802536" y="712277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necteur droit 142"/>
            <p:cNvCxnSpPr/>
            <p:nvPr/>
          </p:nvCxnSpPr>
          <p:spPr>
            <a:xfrm>
              <a:off x="2802536" y="1088518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4" name="Grouper 143"/>
          <p:cNvGrpSpPr/>
          <p:nvPr/>
        </p:nvGrpSpPr>
        <p:grpSpPr>
          <a:xfrm>
            <a:off x="3752938" y="2701726"/>
            <a:ext cx="2097468" cy="211079"/>
            <a:chOff x="1340768" y="6835606"/>
            <a:chExt cx="1671596" cy="153888"/>
          </a:xfrm>
        </p:grpSpPr>
        <p:sp>
          <p:nvSpPr>
            <p:cNvPr id="145" name="Rectangle 25"/>
            <p:cNvSpPr>
              <a:spLocks noChangeArrowheads="1"/>
            </p:cNvSpPr>
            <p:nvPr/>
          </p:nvSpPr>
          <p:spPr bwMode="auto">
            <a:xfrm>
              <a:off x="2044287" y="68356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5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6" name="Rectangle 25"/>
            <p:cNvSpPr>
              <a:spLocks noChangeArrowheads="1"/>
            </p:cNvSpPr>
            <p:nvPr/>
          </p:nvSpPr>
          <p:spPr bwMode="auto">
            <a:xfrm>
              <a:off x="2852064" y="68356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7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7" name="Rectangle 25"/>
            <p:cNvSpPr>
              <a:spLocks noChangeArrowheads="1"/>
            </p:cNvSpPr>
            <p:nvPr/>
          </p:nvSpPr>
          <p:spPr bwMode="auto">
            <a:xfrm>
              <a:off x="1744658" y="68356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4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8" name="Rectangle 25"/>
            <p:cNvSpPr>
              <a:spLocks noChangeArrowheads="1"/>
            </p:cNvSpPr>
            <p:nvPr/>
          </p:nvSpPr>
          <p:spPr bwMode="auto">
            <a:xfrm>
              <a:off x="2448177" y="68356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6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9" name="Rectangle 25"/>
            <p:cNvSpPr>
              <a:spLocks noChangeArrowheads="1"/>
            </p:cNvSpPr>
            <p:nvPr/>
          </p:nvSpPr>
          <p:spPr bwMode="auto">
            <a:xfrm>
              <a:off x="1340768" y="68356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.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150" name="Grouper 149"/>
          <p:cNvGrpSpPr/>
          <p:nvPr/>
        </p:nvGrpSpPr>
        <p:grpSpPr>
          <a:xfrm>
            <a:off x="3816000" y="2642400"/>
            <a:ext cx="1944000" cy="50400"/>
            <a:chOff x="1419002" y="6790931"/>
            <a:chExt cx="1507088" cy="50400"/>
          </a:xfrm>
        </p:grpSpPr>
        <p:cxnSp>
          <p:nvCxnSpPr>
            <p:cNvPr id="151" name="Connecteur droit 150"/>
            <p:cNvCxnSpPr/>
            <p:nvPr/>
          </p:nvCxnSpPr>
          <p:spPr>
            <a:xfrm rot="5400000">
              <a:off x="1771103" y="68150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Connecteur droit 151"/>
            <p:cNvCxnSpPr/>
            <p:nvPr/>
          </p:nvCxnSpPr>
          <p:spPr>
            <a:xfrm rot="5400000">
              <a:off x="2899832" y="68150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cteur droit 152"/>
            <p:cNvCxnSpPr/>
            <p:nvPr/>
          </p:nvCxnSpPr>
          <p:spPr>
            <a:xfrm rot="5400000">
              <a:off x="2523589" y="68150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cteur droit 153"/>
            <p:cNvCxnSpPr/>
            <p:nvPr/>
          </p:nvCxnSpPr>
          <p:spPr>
            <a:xfrm rot="5400000">
              <a:off x="1394860" y="68150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154"/>
            <p:cNvCxnSpPr/>
            <p:nvPr/>
          </p:nvCxnSpPr>
          <p:spPr>
            <a:xfrm rot="5400000">
              <a:off x="2147346" y="6815073"/>
              <a:ext cx="50400" cy="2116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6" name="Grouper 155"/>
          <p:cNvGrpSpPr/>
          <p:nvPr/>
        </p:nvGrpSpPr>
        <p:grpSpPr>
          <a:xfrm>
            <a:off x="3501008" y="840590"/>
            <a:ext cx="366971" cy="1890012"/>
            <a:chOff x="4774973" y="1606539"/>
            <a:chExt cx="366971" cy="1554044"/>
          </a:xfrm>
        </p:grpSpPr>
        <p:sp>
          <p:nvSpPr>
            <p:cNvPr id="157" name="Rectangle 25"/>
            <p:cNvSpPr>
              <a:spLocks noChangeArrowheads="1"/>
            </p:cNvSpPr>
            <p:nvPr/>
          </p:nvSpPr>
          <p:spPr bwMode="auto">
            <a:xfrm>
              <a:off x="4774973" y="3006695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0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58" name="Rectangle 25"/>
            <p:cNvSpPr>
              <a:spLocks noChangeArrowheads="1"/>
            </p:cNvSpPr>
            <p:nvPr/>
          </p:nvSpPr>
          <p:spPr bwMode="auto">
            <a:xfrm flipH="1">
              <a:off x="4774973" y="2446632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0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0.1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59" name="Rectangle 25"/>
            <p:cNvSpPr>
              <a:spLocks noChangeArrowheads="1"/>
            </p:cNvSpPr>
            <p:nvPr/>
          </p:nvSpPr>
          <p:spPr bwMode="auto">
            <a:xfrm flipH="1">
              <a:off x="4774973" y="2726663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0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60" name="Rectangle 25"/>
            <p:cNvSpPr>
              <a:spLocks noChangeArrowheads="1"/>
            </p:cNvSpPr>
            <p:nvPr/>
          </p:nvSpPr>
          <p:spPr bwMode="auto">
            <a:xfrm flipH="1">
              <a:off x="4774973" y="2166601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1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61" name="Rectangle 25"/>
            <p:cNvSpPr>
              <a:spLocks noChangeArrowheads="1"/>
            </p:cNvSpPr>
            <p:nvPr/>
          </p:nvSpPr>
          <p:spPr bwMode="auto">
            <a:xfrm flipH="1">
              <a:off x="4774973" y="1606539"/>
              <a:ext cx="3669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5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62" name="Rectangle 25"/>
            <p:cNvSpPr>
              <a:spLocks noChangeArrowheads="1"/>
            </p:cNvSpPr>
            <p:nvPr/>
          </p:nvSpPr>
          <p:spPr bwMode="auto">
            <a:xfrm flipH="1">
              <a:off x="4774973" y="1886570"/>
              <a:ext cx="3669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20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163" name="Grouper 162"/>
          <p:cNvGrpSpPr/>
          <p:nvPr/>
        </p:nvGrpSpPr>
        <p:grpSpPr>
          <a:xfrm>
            <a:off x="3751200" y="906405"/>
            <a:ext cx="50400" cy="1713600"/>
            <a:chOff x="5141944" y="1705455"/>
            <a:chExt cx="45719" cy="1412403"/>
          </a:xfrm>
        </p:grpSpPr>
        <p:cxnSp>
          <p:nvCxnSpPr>
            <p:cNvPr id="164" name="Connecteur droit 163"/>
            <p:cNvCxnSpPr/>
            <p:nvPr/>
          </p:nvCxnSpPr>
          <p:spPr>
            <a:xfrm flipH="1">
              <a:off x="5141944" y="3116271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cteur droit 164"/>
            <p:cNvCxnSpPr/>
            <p:nvPr/>
          </p:nvCxnSpPr>
          <p:spPr>
            <a:xfrm flipH="1">
              <a:off x="5141944" y="2551945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cteur droit 165"/>
            <p:cNvCxnSpPr/>
            <p:nvPr/>
          </p:nvCxnSpPr>
          <p:spPr>
            <a:xfrm flipH="1">
              <a:off x="5141944" y="1705455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cteur droit 166"/>
            <p:cNvCxnSpPr/>
            <p:nvPr/>
          </p:nvCxnSpPr>
          <p:spPr>
            <a:xfrm flipH="1">
              <a:off x="5141944" y="1987618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Connecteur droit 167"/>
            <p:cNvCxnSpPr/>
            <p:nvPr/>
          </p:nvCxnSpPr>
          <p:spPr>
            <a:xfrm flipH="1">
              <a:off x="5141944" y="2834108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cteur droit 168"/>
            <p:cNvCxnSpPr/>
            <p:nvPr/>
          </p:nvCxnSpPr>
          <p:spPr>
            <a:xfrm flipH="1">
              <a:off x="5141944" y="2269782"/>
              <a:ext cx="45719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323</Words>
  <Application>Microsoft Macintosh PowerPoint</Application>
  <PresentationFormat>Présentation à l'écran (4:3)</PresentationFormat>
  <Paragraphs>8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Symbol</vt:lpstr>
      <vt:lpstr>Times New Roman</vt:lpstr>
      <vt:lpstr>Arial</vt:lpstr>
      <vt:lpstr>Thème Office</vt:lpstr>
      <vt:lpstr>Présentation PowerPoint</vt:lpstr>
    </vt:vector>
  </TitlesOfParts>
  <Company>Universite de Caen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rwan Le Deunff</dc:creator>
  <cp:lastModifiedBy>Utilisateur de Microsoft Office</cp:lastModifiedBy>
  <cp:revision>14</cp:revision>
  <dcterms:created xsi:type="dcterms:W3CDTF">2019-09-30T20:08:33Z</dcterms:created>
  <dcterms:modified xsi:type="dcterms:W3CDTF">2019-10-21T20:06:34Z</dcterms:modified>
</cp:coreProperties>
</file>